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1"/>
  </p:notesMasterIdLst>
  <p:sldIdLst>
    <p:sldId id="345" r:id="rId2"/>
    <p:sldId id="346" r:id="rId3"/>
    <p:sldId id="333" r:id="rId4"/>
    <p:sldId id="334" r:id="rId5"/>
    <p:sldId id="267" r:id="rId6"/>
    <p:sldId id="268" r:id="rId7"/>
    <p:sldId id="269" r:id="rId8"/>
    <p:sldId id="270" r:id="rId9"/>
    <p:sldId id="271" r:id="rId10"/>
    <p:sldId id="272" r:id="rId11"/>
    <p:sldId id="273" r:id="rId12"/>
    <p:sldId id="274" r:id="rId13"/>
    <p:sldId id="275" r:id="rId14"/>
    <p:sldId id="276" r:id="rId15"/>
    <p:sldId id="277" r:id="rId16"/>
    <p:sldId id="278" r:id="rId17"/>
    <p:sldId id="279" r:id="rId18"/>
    <p:sldId id="280" r:id="rId19"/>
    <p:sldId id="281" r:id="rId20"/>
    <p:sldId id="282" r:id="rId21"/>
    <p:sldId id="283" r:id="rId22"/>
    <p:sldId id="284" r:id="rId23"/>
    <p:sldId id="285" r:id="rId24"/>
    <p:sldId id="286" r:id="rId25"/>
    <p:sldId id="287" r:id="rId26"/>
    <p:sldId id="288" r:id="rId27"/>
    <p:sldId id="289" r:id="rId28"/>
    <p:sldId id="290" r:id="rId29"/>
    <p:sldId id="291" r:id="rId30"/>
    <p:sldId id="292" r:id="rId31"/>
    <p:sldId id="293" r:id="rId32"/>
    <p:sldId id="294" r:id="rId33"/>
    <p:sldId id="295" r:id="rId34"/>
    <p:sldId id="296" r:id="rId35"/>
    <p:sldId id="297" r:id="rId36"/>
    <p:sldId id="298" r:id="rId37"/>
    <p:sldId id="299" r:id="rId38"/>
    <p:sldId id="300" r:id="rId39"/>
    <p:sldId id="301" r:id="rId40"/>
    <p:sldId id="302" r:id="rId41"/>
    <p:sldId id="303" r:id="rId42"/>
    <p:sldId id="304" r:id="rId43"/>
    <p:sldId id="305" r:id="rId44"/>
    <p:sldId id="306" r:id="rId45"/>
    <p:sldId id="307" r:id="rId46"/>
    <p:sldId id="308" r:id="rId47"/>
    <p:sldId id="309" r:id="rId48"/>
    <p:sldId id="343" r:id="rId49"/>
    <p:sldId id="311" r:id="rId50"/>
    <p:sldId id="312" r:id="rId51"/>
    <p:sldId id="342" r:id="rId52"/>
    <p:sldId id="314" r:id="rId53"/>
    <p:sldId id="315" r:id="rId54"/>
    <p:sldId id="316" r:id="rId55"/>
    <p:sldId id="317" r:id="rId56"/>
    <p:sldId id="318" r:id="rId57"/>
    <p:sldId id="319" r:id="rId58"/>
    <p:sldId id="320" r:id="rId59"/>
    <p:sldId id="321" r:id="rId60"/>
    <p:sldId id="322" r:id="rId61"/>
    <p:sldId id="323" r:id="rId62"/>
    <p:sldId id="341" r:id="rId63"/>
    <p:sldId id="325" r:id="rId64"/>
    <p:sldId id="326" r:id="rId65"/>
    <p:sldId id="327" r:id="rId66"/>
    <p:sldId id="328" r:id="rId67"/>
    <p:sldId id="329" r:id="rId68"/>
    <p:sldId id="330" r:id="rId69"/>
    <p:sldId id="331" r:id="rId70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9441" autoAdjust="0"/>
  </p:normalViewPr>
  <p:slideViewPr>
    <p:cSldViewPr>
      <p:cViewPr>
        <p:scale>
          <a:sx n="55" d="100"/>
          <a:sy n="55" d="100"/>
        </p:scale>
        <p:origin x="-1806" y="-4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7" Type="http://schemas.openxmlformats.org/officeDocument/2006/relationships/slide" Target="slides/slide6.xml"/><Relationship Id="rId71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slide" Target="slides/slide60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presProps" Target="pres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E6F20A-3B6B-4D3F-89E6-1FD6BB110DE9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377252-890E-4F95-8136-B4878C4F6C2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9504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/>
              <a:t>Neurotoxin </a:t>
            </a:r>
            <a:r>
              <a:rPr lang="en-US" sz="1200" b="1" dirty="0" err="1" smtClean="0"/>
              <a:t>BmK</a:t>
            </a:r>
            <a:r>
              <a:rPr lang="en-US" sz="1200" b="1" dirty="0" smtClean="0"/>
              <a:t>-II (</a:t>
            </a:r>
            <a:r>
              <a:rPr lang="en-US" sz="1200" b="1" dirty="0" smtClean="0">
                <a:solidFill>
                  <a:srgbClr val="FF0000"/>
                </a:solidFill>
              </a:rPr>
              <a:t>P59360); </a:t>
            </a:r>
            <a:r>
              <a:rPr lang="en-US" sz="1200" b="1" dirty="0" smtClean="0"/>
              <a:t>Beta-insect depressant toxin BaIT2 (</a:t>
            </a:r>
            <a:r>
              <a:rPr lang="en-US" sz="1200" b="1" dirty="0" smtClean="0">
                <a:solidFill>
                  <a:srgbClr val="FF0000"/>
                </a:solidFill>
              </a:rPr>
              <a:t>P80962); </a:t>
            </a:r>
            <a:r>
              <a:rPr lang="en-US" sz="1200" b="1" dirty="0" smtClean="0"/>
              <a:t>Insect toxin BsIT4</a:t>
            </a:r>
            <a:r>
              <a:rPr lang="en-US" sz="1200" dirty="0" smtClean="0"/>
              <a:t> (</a:t>
            </a:r>
            <a:r>
              <a:rPr lang="en-US" sz="1200" b="1" dirty="0" smtClean="0">
                <a:solidFill>
                  <a:srgbClr val="FF0000"/>
                </a:solidFill>
              </a:rPr>
              <a:t>P82814);</a:t>
            </a:r>
            <a:r>
              <a:rPr lang="en-US" sz="1200" b="1" baseline="0" dirty="0" smtClean="0">
                <a:solidFill>
                  <a:srgbClr val="FF0000"/>
                </a:solidFill>
              </a:rPr>
              <a:t> </a:t>
            </a:r>
            <a:r>
              <a:rPr lang="en-US" sz="1200" b="1" dirty="0" smtClean="0"/>
              <a:t>Insect toxin LqhIT5 </a:t>
            </a:r>
            <a:r>
              <a:rPr lang="fr-FR" sz="1200" b="0" dirty="0" smtClean="0"/>
              <a:t>(</a:t>
            </a:r>
            <a:r>
              <a:rPr lang="en-US" sz="1200" b="1" dirty="0" smtClean="0">
                <a:solidFill>
                  <a:srgbClr val="FF0000"/>
                </a:solidFill>
              </a:rPr>
              <a:t>P81240)</a:t>
            </a:r>
            <a:r>
              <a:rPr lang="en-US" sz="1200" b="0" dirty="0" smtClean="0">
                <a:solidFill>
                  <a:schemeClr val="tx1"/>
                </a:solidFill>
              </a:rPr>
              <a:t>;</a:t>
            </a:r>
            <a:r>
              <a:rPr lang="en-US" sz="1200" b="0" baseline="0" dirty="0" smtClean="0">
                <a:solidFill>
                  <a:schemeClr val="tx1"/>
                </a:solidFill>
              </a:rPr>
              <a:t> </a:t>
            </a:r>
            <a:r>
              <a:rPr lang="en-US" sz="1200" b="1" dirty="0" smtClean="0"/>
              <a:t>Beta-insect depressant toxin BotIT4 (</a:t>
            </a:r>
            <a:r>
              <a:rPr lang="en-US" sz="1200" b="1" dirty="0" smtClean="0">
                <a:solidFill>
                  <a:srgbClr val="FF0000"/>
                </a:solidFill>
              </a:rPr>
              <a:t>P55903)</a:t>
            </a:r>
            <a:endParaRPr lang="fr-FR" sz="1200" b="1" dirty="0" smtClean="0">
              <a:solidFill>
                <a:srgbClr val="FF0000"/>
              </a:solidFill>
            </a:endParaRPr>
          </a:p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A451C5-366E-4BA1-BC90-2FC9B8A54566}" type="slidenum">
              <a:rPr lang="en-US" smtClean="0"/>
              <a:t>4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3339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)</a:t>
            </a:r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A451C5-366E-4BA1-BC90-2FC9B8A54566}" type="slidenum">
              <a:rPr lang="en-US" smtClean="0"/>
              <a:t>6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813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6073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1550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043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233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7067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73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9654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6688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5054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432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1207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6BF9CB-F4B1-4C94-869F-C3505E1BADF2}" type="datetimeFigureOut">
              <a:rPr lang="fr-FR" smtClean="0"/>
              <a:t>18/02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7C8DF0-E758-404B-B3E1-73CF74E25CD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291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6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066800" y="1828800"/>
            <a:ext cx="7467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>
                <a:solidFill>
                  <a:srgbClr val="FFC000"/>
                </a:solidFill>
              </a:rPr>
              <a:t>Detected amino acid sequences of the 68 peptides identified by Top-down approach</a:t>
            </a:r>
            <a:endParaRPr lang="en-US" sz="3600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993362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10668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10242" name="Picture 2" descr="C:\Users\Khadija\Desktop\sUPP\O77091 (Chain(Beta-insect excitatory toxin BmK IT-AP) [19-90] in Beta-insect excitatory toxin BmK IT-AP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472" y="4038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19472" y="2029361"/>
            <a:ext cx="9149252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: </a:t>
            </a:r>
            <a:endParaRPr lang="fr-FR" sz="2000" b="1" dirty="0" smtClean="0"/>
          </a:p>
          <a:p>
            <a:endParaRPr lang="fr-FR" sz="2000" dirty="0"/>
          </a:p>
          <a:p>
            <a:r>
              <a:rPr lang="en-US" sz="2000" b="1" dirty="0">
                <a:solidFill>
                  <a:srgbClr val="FF0000"/>
                </a:solidFill>
              </a:rPr>
              <a:t>MKFFLIFLVIFPIMGVLGKKNGYAVDSSGKVAECLFNNYCNNECTKVYYADKGYCCLLKCYCFGLADDKPVLDIWDSTKNYCDVQIIDLS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118181" y="30657"/>
            <a:ext cx="8726676" cy="18774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(Beta-insect excitatory toxin </a:t>
            </a:r>
            <a:r>
              <a:rPr lang="en-US" sz="2000" b="1" dirty="0" err="1"/>
              <a:t>BmK</a:t>
            </a:r>
            <a:r>
              <a:rPr lang="en-US" sz="2000" b="1" dirty="0"/>
              <a:t> IT-AP) [19-90] in Beta-insect excitatory toxin </a:t>
            </a:r>
            <a:r>
              <a:rPr lang="en-US" sz="2000" b="1" dirty="0" err="1"/>
              <a:t>BmK</a:t>
            </a:r>
            <a:r>
              <a:rPr lang="en-US" sz="2000" b="1" dirty="0"/>
              <a:t> IT-AP </a:t>
            </a:r>
            <a:endParaRPr lang="en-US" sz="2000" b="1" dirty="0" smtClean="0"/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O77091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943,53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80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50254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09600" y="5334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11266" name="Picture 2" descr="C:\Users\Khadija\Desktop\sUPP\P21150 (Toxin AaHIT4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12" y="4167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4" name="Rectangle 13"/>
          <p:cNvSpPr/>
          <p:nvPr/>
        </p:nvSpPr>
        <p:spPr>
          <a:xfrm>
            <a:off x="1143000" y="3390379"/>
            <a:ext cx="345456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1103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EHGYLLNKYTGCKVWCVINNEECGYLCNKRRGGYYGYCYFWKLACYCQGARKSELWNYKTNKCDL</a:t>
            </a:r>
            <a:r>
              <a:rPr lang="en-US" sz="2000" dirty="0">
                <a:solidFill>
                  <a:srgbClr val="FF0000"/>
                </a:solidFill>
              </a:rPr>
              <a:t>	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11601" y="381000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Toxin </a:t>
            </a:r>
            <a:r>
              <a:rPr lang="en-US" sz="2000" b="1" dirty="0"/>
              <a:t>AaHIT4</a:t>
            </a:r>
            <a:r>
              <a:rPr lang="en-US" sz="2000" dirty="0"/>
              <a:t>	</a:t>
            </a:r>
            <a:r>
              <a:rPr lang="en-US" sz="2000" dirty="0" smtClean="0"/>
              <a:t>                                                                  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21150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791,58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98,48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44958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0" y="28288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100	6845,9</a:t>
            </a:r>
          </a:p>
        </p:txBody>
      </p:sp>
      <p:pic>
        <p:nvPicPr>
          <p:cNvPr id="12289" name="Picture 1" descr="C:\Users\Khadija\Desktop\sUPP\P80962 (Beta-insect depressant toxin BaIT2) imp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962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10064" y="1771796"/>
            <a:ext cx="92548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</a:t>
            </a:r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DGYIRRRDGCKVSCLFGNEGCDKECKAYGGSYGYCWTWGLACWCEGLPDDKTWKSETNTCG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Beta-insect depressant toxin BaIT2</a:t>
            </a:r>
            <a:r>
              <a:rPr lang="en-US" sz="2000" b="1" dirty="0" smtClean="0"/>
              <a:t>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80962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791,58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98,48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29540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12954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13314" name="Picture 2" descr="C:\Users\Khadija\Desktop\sUPP\P01485 (Alpha-mammal toxin Bot3; Chain (Alpha-mammal toxin Bot3) [10-73] in Alpha-mammal toxin Bot3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7255" y="3657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22860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</a:t>
            </a:r>
            <a:r>
              <a:rPr lang="fr-FR" sz="2000" b="1" dirty="0" err="1" smtClean="0"/>
              <a:t>Database</a:t>
            </a:r>
            <a:r>
              <a:rPr lang="fr-FR" sz="2000" b="1" dirty="0" smtClean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 </a:t>
            </a:r>
          </a:p>
          <a:p>
            <a:endParaRPr lang="fr-FR" sz="2000" b="1" dirty="0">
              <a:solidFill>
                <a:srgbClr val="FF0000"/>
              </a:solidFill>
            </a:endParaRPr>
          </a:p>
          <a:p>
            <a:r>
              <a:rPr lang="en-US" sz="2000" b="1" dirty="0" smtClean="0">
                <a:solidFill>
                  <a:srgbClr val="FF0000"/>
                </a:solidFill>
              </a:rPr>
              <a:t>LVMAGVESVKDGYIVDDRNCTYFCGRNAYCNEECTKLKGESGYCQWASPYGNACYCYKVPDHVRTKGPGRCN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108103" y="228600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lpha-mammal toxin Bot3; Chain (Alpha-mammal toxin Bot3) [10-73] in Alpha-mammal toxin Bot3</a:t>
            </a:r>
            <a:r>
              <a:rPr lang="en-US" sz="2000" dirty="0"/>
              <a:t>	</a:t>
            </a:r>
            <a:endParaRPr lang="fr-FR" sz="2000" dirty="0"/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01485</a:t>
            </a:r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288268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89,18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87,67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173085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345303" y="164467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14337" name="Picture 1" descr="C:\Users\Khadija\Desktop\sUPP\Q86BW9 (Chain (Makatoxin-2) [20-83] in Makatoxin-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776" y="3962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-76200" y="1967098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 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IVISFALLLMTSVESGRDAYIADSENCTYFCGSNPYCNDLCTENGAKSGYCQWAGRYGNACWCIDLPDKVPIRIPGPCRGR</a:t>
            </a:r>
            <a:r>
              <a:rPr lang="en-US" sz="2000" dirty="0"/>
              <a:t>	</a:t>
            </a:r>
            <a:endParaRPr lang="fr-FR" sz="2000" dirty="0" smtClean="0"/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Chain (Makatoxin-2) [20-83] in </a:t>
            </a:r>
            <a:r>
              <a:rPr lang="en-US" sz="2000" b="1" dirty="0" smtClean="0"/>
              <a:t>Makatoxin-2    </a:t>
            </a:r>
            <a:r>
              <a:rPr lang="fr-FR" sz="2000" b="1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86BW9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062,11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75,29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84369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C:\Users\Khadija\Desktop\sUPP\G4V3T9 (Neurotoxin BmK AGAP-SYPU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419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524000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: 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KDGYIVDDKNCAYFCGRNAYCDDECEKNGAESGYCQWAGVYGNACWCYKLPDKVPIRVPGRCNG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6" name="Rectangle 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Neurotoxin </a:t>
            </a:r>
            <a:r>
              <a:rPr lang="en-US" sz="2000" b="1" dirty="0" err="1"/>
              <a:t>BmK</a:t>
            </a:r>
            <a:r>
              <a:rPr lang="en-US" sz="2000" b="1" dirty="0"/>
              <a:t> AGAP-SYPU2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G4V3T9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7" name="Rectangle 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89,18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48</a:t>
            </a:r>
            <a:r>
              <a:rPr lang="en-US" b="1" dirty="0">
                <a:solidFill>
                  <a:srgbClr val="FFC000"/>
                </a:solidFill>
              </a:rPr>
              <a:t>	</a:t>
            </a:r>
            <a:r>
              <a:rPr lang="en-US" b="1" dirty="0" smtClean="0">
                <a:solidFill>
                  <a:srgbClr val="FFC000"/>
                </a:solidFill>
              </a:rPr>
              <a:t>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499100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590800" y="1714143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16385" name="Picture 1" descr="C:\Users\Khadija\Desktop\sUPP\P84614 (Alpha-toxin Bs-Tx28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35" y="4029165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-14578" y="2091480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: </a:t>
            </a:r>
            <a:endParaRPr lang="fr-FR" sz="2000" b="1" dirty="0" smtClean="0"/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VRDAYIADDKNCVYTCGSNSYCNTECTKNGAESGYCQWFGRWGNGCWCIKLPDKVPIRIPGKCR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lpha-toxin Bs-Tx28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8461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14,2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98,48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494414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743200" y="2379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17409" name="Picture 1" descr="C:\Users\Khadija\Desktop\sUPP\Q9BLM4 (Toxin AahP1005; Chain (Toxin AahP1005) [20-83] in Toxin AahP1005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33" y="3962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228600" y="1771796"/>
            <a:ext cx="9254878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MNYLVMISLALLFMTGVESKKDGYIVDDKNCTFFCGRNAYCNDECKKKGAESGYCQWASPYGNACYCYKLPDRVSTKKKGGCNGR</a:t>
            </a:r>
          </a:p>
          <a:p>
            <a:r>
              <a:rPr lang="fr-FR" sz="2000" b="1" dirty="0" smtClean="0"/>
              <a:t> </a:t>
            </a:r>
            <a:endParaRPr lang="fr-FR" sz="2000" b="1" dirty="0"/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8774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Toxin AahP1005; Chain (Toxin AahP1005) [20-83] in Toxin AahP1005 </a:t>
            </a:r>
            <a:r>
              <a:rPr lang="fr-FR" sz="2000" b="1" dirty="0" smtClean="0"/>
              <a:t>                            </a:t>
            </a:r>
          </a:p>
          <a:p>
            <a:pPr algn="just"/>
            <a:endParaRPr lang="en-US" sz="2000" dirty="0" smtClean="0"/>
          </a:p>
          <a:p>
            <a:pPr algn="just"/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Q9BLM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 7316,26</a:t>
            </a:r>
            <a:r>
              <a:rPr lang="en-US" b="1" dirty="0" smtClean="0">
                <a:solidFill>
                  <a:srgbClr val="FFC000"/>
                </a:solidFill>
              </a:rPr>
              <a:t>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75,29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30460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 descr="C:\Users\Khadija\Desktop\sUPP\P86408 (Neurotoxin MeuNaTx-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193126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</a:t>
            </a:r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: </a:t>
            </a:r>
            <a:endParaRPr lang="fr-FR" sz="2000" b="1" dirty="0" smtClean="0"/>
          </a:p>
          <a:p>
            <a:endParaRPr lang="fr-FR" sz="2000" b="1" dirty="0"/>
          </a:p>
          <a:p>
            <a:r>
              <a:rPr lang="en-US" sz="2000" b="1" dirty="0">
                <a:solidFill>
                  <a:srgbClr val="FF0000"/>
                </a:solidFill>
              </a:rPr>
              <a:t>MVRDGYIADDKNCAYFCGRNAYCDEECKKKGAESGYCQWAGQYGNACWCYKLPDKVPIKVSGKCN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Neurotoxin </a:t>
            </a:r>
            <a:r>
              <a:rPr lang="en-US" sz="2000" b="1" dirty="0"/>
              <a:t>MeuNaTx-1</a:t>
            </a:r>
            <a:r>
              <a:rPr lang="en-US" sz="2000" dirty="0"/>
              <a:t>		</a:t>
            </a:r>
            <a:r>
              <a:rPr lang="en-US" sz="2000" dirty="0" smtClean="0"/>
              <a:t>         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8640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7218,31</a:t>
            </a:r>
            <a:r>
              <a:rPr lang="en-US" b="1" dirty="0" smtClean="0">
                <a:solidFill>
                  <a:srgbClr val="FFC000"/>
                </a:solidFill>
              </a:rPr>
              <a:t>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98,46</a:t>
            </a:r>
            <a:r>
              <a:rPr lang="en-US" b="1" dirty="0" smtClean="0">
                <a:solidFill>
                  <a:srgbClr val="FFC000"/>
                </a:solidFill>
              </a:rPr>
              <a:t>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60951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 descr="C:\Users\Khadija\Desktop\sUPP\P60255 (Toxin Boma6a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37338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0" y="1600200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AYIAQNYNCVYDCARDAYCNDLCTKNGAKSGYCEWFGPHGDACWCIDLPNNVPIKVEGKCHRK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44897" y="152400"/>
            <a:ext cx="8693149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Toxin Boma6a</a:t>
            </a:r>
            <a:r>
              <a:rPr lang="en-US" sz="2000" dirty="0"/>
              <a:t>			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60255</a:t>
            </a:r>
            <a:r>
              <a:rPr lang="en-US" sz="2000" dirty="0"/>
              <a:t>	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7221,18</a:t>
            </a:r>
            <a:r>
              <a:rPr lang="en-US" b="1" dirty="0" smtClean="0">
                <a:solidFill>
                  <a:srgbClr val="FFC000"/>
                </a:solidFill>
              </a:rPr>
              <a:t>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5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47188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Khadija\Desktop\sUPP\P59356 (Alpha-like toxin Lqh6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0908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0" y="1776874"/>
            <a:ext cx="92202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dirty="0" smtClean="0"/>
          </a:p>
          <a:p>
            <a:endParaRPr lang="en-US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GYIAQPENCVYHCIPDCDTLCKDNGGTGGHCGFKLGHGIACWCNALPDNVGIIVDGVKCHK</a:t>
            </a:r>
            <a:r>
              <a:rPr lang="en-US" sz="2000" b="1" dirty="0">
                <a:solidFill>
                  <a:srgbClr val="FF0000"/>
                </a:solidFill>
              </a:rPr>
              <a:t>	</a:t>
            </a:r>
          </a:p>
          <a:p>
            <a:endParaRPr lang="en-US" sz="2000" b="1" dirty="0">
              <a:solidFill>
                <a:srgbClr val="FF0000"/>
              </a:solidFill>
            </a:endParaRPr>
          </a:p>
        </p:txBody>
      </p:sp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4" name="Rectangle 13"/>
          <p:cNvSpPr/>
          <p:nvPr/>
        </p:nvSpPr>
        <p:spPr>
          <a:xfrm>
            <a:off x="1143000" y="3390379"/>
            <a:ext cx="73152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</a:t>
            </a:r>
            <a:r>
              <a:rPr lang="fr-FR" b="1" dirty="0">
                <a:solidFill>
                  <a:srgbClr val="FFC000"/>
                </a:solidFill>
              </a:rPr>
              <a:t>: </a:t>
            </a:r>
            <a:r>
              <a:rPr lang="en-US" b="1" dirty="0">
                <a:solidFill>
                  <a:srgbClr val="FFC000"/>
                </a:solidFill>
              </a:rPr>
              <a:t>6974,21  Da                            Sequence coverage:  98,46%</a:t>
            </a:r>
            <a:r>
              <a:rPr lang="en-US" dirty="0"/>
              <a:t>	</a:t>
            </a:r>
          </a:p>
          <a:p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17722" y="1771796"/>
            <a:ext cx="925487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:</a:t>
            </a:r>
            <a:endParaRPr lang="fr-FR" sz="2000" b="1" dirty="0" smtClean="0"/>
          </a:p>
          <a:p>
            <a:r>
              <a:rPr lang="fr-FR" sz="2000" dirty="0" smtClean="0"/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49523" y="228600"/>
            <a:ext cx="872667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lpha-like toxin </a:t>
            </a:r>
            <a:r>
              <a:rPr lang="en-US" sz="2000" b="1" dirty="0" smtClean="0"/>
              <a:t>Lqh6</a:t>
            </a:r>
            <a:r>
              <a:rPr lang="fr-FR" sz="2000" b="1" dirty="0"/>
              <a:t> </a:t>
            </a:r>
            <a:r>
              <a:rPr lang="fr-FR" sz="2000" b="1" dirty="0" smtClean="0"/>
              <a:t> </a:t>
            </a:r>
            <a:r>
              <a:rPr lang="fr-FR" sz="2000" dirty="0" smtClean="0"/>
              <a:t>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59356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95947555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447800" y="9906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1025" name="Picture 1" descr="C:\Users\Khadija\Desktop\sUPP\P15225 (Neurotoxin Os3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038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" name="Groupe 4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6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ZoneTexte 6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8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2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ZoneTexte 12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4" name="Rectangle 13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-71047" y="1774742"/>
            <a:ext cx="9254878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VRDGYIAQPHNCVYHCFPGSGGCDTLCKENGATQGSSCFILGRGTACWCKDLPDRVGVIVDGEKCH</a:t>
            </a:r>
            <a:r>
              <a:rPr lang="en-US" sz="2000" b="1" dirty="0">
                <a:solidFill>
                  <a:srgbClr val="FF0000"/>
                </a:solidFill>
              </a:rPr>
              <a:t>	</a:t>
            </a:r>
            <a:r>
              <a:rPr lang="en-US" sz="2000" dirty="0"/>
              <a:t>	</a:t>
            </a:r>
            <a:endParaRPr lang="fr-FR" sz="2000" b="1" dirty="0" smtClean="0"/>
          </a:p>
          <a:p>
            <a:endParaRPr lang="fr-FR" sz="2000" b="1" dirty="0"/>
          </a:p>
        </p:txBody>
      </p:sp>
      <p:sp>
        <p:nvSpPr>
          <p:cNvPr id="17" name="Rectangle 16"/>
          <p:cNvSpPr/>
          <p:nvPr/>
        </p:nvSpPr>
        <p:spPr>
          <a:xfrm>
            <a:off x="228601" y="0"/>
            <a:ext cx="8580052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Neurotoxin Os3</a:t>
            </a:r>
            <a:r>
              <a:rPr lang="en-US" sz="2000" b="1" dirty="0" smtClean="0"/>
              <a:t>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15225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571007" y="3302962"/>
            <a:ext cx="836659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6957,15     Da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98,52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671377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797511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2050" name="Picture 2" descr="C:\Users\Khadija\Desktop\sUPP\P45697 (Alpha-like toxin BmK-M1; Chain (Alpha-like toxin BmK-M1) [20-83] in Alpha-like toxin BmK-M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" y="3778406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-34678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dirty="0" smtClean="0"/>
              <a:t>:</a:t>
            </a:r>
          </a:p>
          <a:p>
            <a:endParaRPr lang="fr-FR" sz="2000" b="1" dirty="0">
              <a:solidFill>
                <a:srgbClr val="FF0000"/>
              </a:solidFill>
            </a:endParaRPr>
          </a:p>
          <a:p>
            <a:r>
              <a:rPr lang="en-US" sz="2000" b="1" dirty="0" smtClean="0">
                <a:solidFill>
                  <a:srgbClr val="FF0000"/>
                </a:solidFill>
              </a:rPr>
              <a:t>MNYLVMISFALLLMTGVESVRDAYIAKPHNCVYECARNEYCNDLCTKNGAKSGYCQWVGKYGNGCWCIELPDNVPIRVPGKCHR</a:t>
            </a:r>
            <a:r>
              <a:rPr lang="en-US" sz="2000" dirty="0"/>
              <a:t>	</a:t>
            </a:r>
            <a:r>
              <a:rPr lang="fr-FR" sz="2000" dirty="0" smtClean="0"/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13361" y="228124"/>
            <a:ext cx="8722342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Alpha-like toxin BmK-M1; Chain (Alpha-like toxin BmK-M1) [20-83] in Alpha-like toxin </a:t>
            </a:r>
            <a:r>
              <a:rPr lang="en-US" sz="2000" b="1" dirty="0" smtClean="0"/>
              <a:t>BmK-M1</a:t>
            </a:r>
          </a:p>
          <a:p>
            <a:pPr algn="just"/>
            <a:r>
              <a:rPr lang="en-US" sz="2000" b="1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45697</a:t>
            </a:r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429,4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76,19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199746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057400" y="901983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3074" name="Picture 2" descr="C:\Users\Khadija\Desktop\sUPP\E4VP24 (Chain [20-85] in Sodium channel neurotoxin MeuNaTxalpha-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3759711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SLVMISLALLVMTGVESVRDGYIADDKNCAYFCGRNAYCDEECKKKGAESGYCQWAGQYGNACWCYKLPDKVPIKVSGKCNGR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99427" y="286430"/>
            <a:ext cx="8726676" cy="984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[20-85] in Sodium channel neurotoxin MeuNaTxalpha-1 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E4VP24</a:t>
            </a:r>
            <a:r>
              <a:rPr lang="en-US" sz="2000" dirty="0"/>
              <a:t>	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336,32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77,64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285203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Khadija\Desktop\sUPP\P55902 (alpha-insect toxin BotIT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810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32657" y="225160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AYIAQNYNCVYFCMKDDYCNDLCTKNGASSGYCQWAGKYGNACWCYALPDNVPIRIPGKCHS</a:t>
            </a:r>
            <a:r>
              <a:rPr lang="en-US" sz="2000" dirty="0"/>
              <a:t>	</a:t>
            </a:r>
            <a:endParaRPr lang="fr-FR" sz="2000" b="1" dirty="0"/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Alpha-insect </a:t>
            </a:r>
            <a:r>
              <a:rPr lang="en-US" sz="2000" b="1" dirty="0"/>
              <a:t>toxin BotIT1</a:t>
            </a:r>
            <a:r>
              <a:rPr lang="en-US" sz="2000" dirty="0"/>
              <a:t>		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55902</a:t>
            </a:r>
            <a:r>
              <a:rPr lang="en-US" sz="2000" dirty="0"/>
              <a:t>	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345.15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48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066775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71800" y="1213008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5122" name="Picture 2" descr="C:\Users\Khadija\Desktop\sUPP\E7CAU3 (Chain (Neurotoxin BmK AGP-SYPU1) [2-65] in Neurotoxin BmK AGP-SYPU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038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38945" y="1771796"/>
            <a:ext cx="9444533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</a:t>
            </a:r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RDAYIAQNYNCVYHCFRDDYCNGLCTENGADSGYCYLAGKYGHACWCINLPDDKPIRIPGK</a:t>
            </a:r>
          </a:p>
          <a:p>
            <a:r>
              <a:rPr lang="en-US" sz="2000" b="1" dirty="0" smtClean="0">
                <a:solidFill>
                  <a:srgbClr val="FF0000"/>
                </a:solidFill>
              </a:rPr>
              <a:t>CHRR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49523" y="-76200"/>
            <a:ext cx="8726676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Neurotoxin </a:t>
            </a:r>
            <a:r>
              <a:rPr lang="en-US" sz="2000" b="1" dirty="0" err="1"/>
              <a:t>BmK</a:t>
            </a:r>
            <a:r>
              <a:rPr lang="en-US" sz="2000" b="1" dirty="0"/>
              <a:t> AGP-SYPU1) [2-65] in Neurotoxin </a:t>
            </a:r>
            <a:r>
              <a:rPr lang="en-US" sz="2000" b="1" dirty="0" err="1"/>
              <a:t>BmK</a:t>
            </a:r>
            <a:r>
              <a:rPr lang="en-US" sz="2000" b="1" dirty="0"/>
              <a:t> AGP-SYPU1 </a:t>
            </a:r>
            <a:endParaRPr lang="en-US" sz="2000" b="1" dirty="0" smtClean="0"/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E7CAU3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 7488,32 </a:t>
            </a:r>
            <a:r>
              <a:rPr lang="en-US" b="1" dirty="0" smtClean="0">
                <a:solidFill>
                  <a:srgbClr val="FFC000"/>
                </a:solidFill>
              </a:rPr>
              <a:t>Da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98,5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537014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092764" y="97157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6146" name="Picture 2" descr="C:\Users\Khadija\Desktop\sUPP\Q1I178 (Toxin Td9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038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-7620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IGMVAECKDGYLVGDDGCKMHCFTRPGHYCASECSRVKGKDGYCYAWLACYCYNMPNWAPIWNSATNSCGKGK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84188" y="109716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Toxin Td9</a:t>
            </a:r>
            <a:r>
              <a:rPr lang="en-US" sz="2000" b="1" dirty="0" smtClean="0"/>
              <a:t>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1I17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076,01 Da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86,48</a:t>
            </a:r>
            <a:r>
              <a:rPr lang="en-US" b="1" dirty="0" smtClean="0">
                <a:solidFill>
                  <a:srgbClr val="FFC000"/>
                </a:solidFill>
              </a:rPr>
              <a:t>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777551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421616" y="1295400"/>
            <a:ext cx="4572000" cy="36933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7170" name="Picture 2" descr="C:\Users\Khadija\Desktop\sUPP\A0A146CJ90 (Chain [20-87] in Venom toxin meuNa3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962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22860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ILISFALLVITGVESARDAYIAQNYNCVYFCLNPWSSYCDDLCTKNGAKSGYCQIFGKYGNACWCIDLPDKVPIRIPGKCHFA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197525" y="193574"/>
            <a:ext cx="8726676" cy="12618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Chain [20-87] in Venom toxin meuNa32</a:t>
            </a:r>
            <a:r>
              <a:rPr lang="en-US" sz="2000" b="1" dirty="0" smtClean="0"/>
              <a:t>          </a:t>
            </a:r>
            <a:r>
              <a:rPr lang="fr-FR" sz="2000" b="1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A0A146CJ90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690,37 Da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78,16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5084689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Khadija\Desktop\sUPP\P68410 (Alpha-mammal toxin Ts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6482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KEGYAMDHEGCKFSCFIRPAGFCDGYCKTHLKASSGYCAWPACYCYGVPDHIKVWDYATNKC</a:t>
            </a:r>
            <a:r>
              <a:rPr lang="en-US" sz="2000" b="1" dirty="0">
                <a:solidFill>
                  <a:srgbClr val="FF0000"/>
                </a:solidFill>
              </a:rPr>
              <a:t>	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dirty="0" smtClean="0"/>
              <a:t>Alpha-mammal </a:t>
            </a:r>
            <a:r>
              <a:rPr lang="en-US" sz="2000" dirty="0"/>
              <a:t>toxin Ts2		</a:t>
            </a:r>
            <a:r>
              <a:rPr lang="en-US" sz="2000" dirty="0" smtClean="0"/>
              <a:t>                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68410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6655,84</a:t>
            </a:r>
            <a:r>
              <a:rPr lang="en-US" b="1" dirty="0" smtClean="0">
                <a:solidFill>
                  <a:srgbClr val="FFC000"/>
                </a:solidFill>
              </a:rPr>
              <a:t>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41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876376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295378" y="357579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9218" name="Picture 2" descr="C:\Users\Khadija\Desktop\sUPP\P68726 (Chain (Insect toxin 2-53) [22-82] in Insect toxin 2-53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306163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>
                <a:solidFill>
                  <a:srgbClr val="FF0000"/>
                </a:solidFill>
              </a:rPr>
              <a:t>MKLLLLLIVSASMLIESLVNADGYIKRRDGCKVACLVGNEGCDKECKAYGGSYGYCWTWGLACWCEGLPDDKTWKSETNTCGGKK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140702" y="-57919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Insect toxin 2-53) [22-82] in Insect toxin 2-53</a:t>
            </a:r>
            <a:r>
              <a:rPr lang="en-US" sz="2000" b="1" dirty="0" smtClean="0"/>
              <a:t> </a:t>
            </a:r>
            <a:endParaRPr lang="fr-FR" sz="2000" dirty="0"/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68726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6739,87 Da                     Sequence coverage: 71,76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7508094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71800" y="962395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10242" name="Picture 2" descr="C:\Users\Khadija\Desktop\sUPP\Q1I163 (Toxin Td8; Chain (Toxin Td8) [21-83] in Toxin Td8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5489" y="4351666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TRFVLFLSCFFLIGMVVECKDGYLVGDDGCKMHCFTRPGHYCASECSRVKGKDGYCYAWLACYCYNMPNWAPIWNSATNRCRGRK</a:t>
            </a:r>
            <a:r>
              <a:rPr lang="en-US" sz="2000" dirty="0"/>
              <a:t>	</a:t>
            </a:r>
            <a:endParaRPr lang="fr-FR" sz="2000" dirty="0" smtClean="0"/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Toxin Td8; Chain (Toxin Td8) [21-83] in Toxin </a:t>
            </a:r>
            <a:r>
              <a:rPr lang="en-US" sz="2000" b="1" dirty="0" smtClean="0"/>
              <a:t>Td8</a:t>
            </a:r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1I163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990608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6986,05 Da                     Sequence coverage: 73,25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1812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828800" y="13716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3073" name="Picture 1" descr="C:\Users\Khadija\Desktop\sUPP\P13488 (Alpha-like toxin Bom3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39" y="4038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4" name="Rectangle 13"/>
          <p:cNvSpPr/>
          <p:nvPr/>
        </p:nvSpPr>
        <p:spPr>
          <a:xfrm>
            <a:off x="1143000" y="3390379"/>
            <a:ext cx="746732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  </a:t>
            </a:r>
            <a:r>
              <a:rPr lang="en-US" b="1" dirty="0">
                <a:solidFill>
                  <a:srgbClr val="FFC000"/>
                </a:solidFill>
              </a:rPr>
              <a:t>7012.14 </a:t>
            </a:r>
            <a:r>
              <a:rPr lang="en-US" b="1" dirty="0" smtClean="0">
                <a:solidFill>
                  <a:srgbClr val="FFC000"/>
                </a:solidFill>
              </a:rPr>
              <a:t> Da              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 98.5%</a:t>
            </a:r>
          </a:p>
          <a:p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-7620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</a:p>
          <a:p>
            <a:endParaRPr lang="fr-FR" sz="2000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RDGYIAQPENCVYHCFPGSSGCDTLCKEKGATSGHCGFLPGSGVACWCDNLPNKVPIVVGGEKCH</a:t>
            </a:r>
            <a:r>
              <a:rPr lang="en-US" sz="2000" dirty="0"/>
              <a:t>	</a:t>
            </a:r>
            <a:r>
              <a:rPr lang="fr-FR" sz="2000" dirty="0" smtClean="0"/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49523" y="338316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lpha-like toxin Bom3 </a:t>
            </a:r>
            <a:r>
              <a:rPr lang="fr-FR" sz="2000" b="1" dirty="0"/>
              <a:t> </a:t>
            </a:r>
            <a:r>
              <a:rPr lang="fr-FR" sz="2000" b="1" dirty="0" smtClean="0"/>
              <a:t>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1348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293121770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81000" y="219005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11266" name="Picture 2" descr="C:\Users\Khadija\Desktop\sUPP\P56569 (Makatoxin-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3447" y="4186594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RDAYIADSENCTYTCALNPYCNDLCTKNGAKSGYCQWAGRYGNACWCIDLPDKVPIRISGSCR</a:t>
            </a:r>
            <a:r>
              <a:rPr lang="en-US" sz="2000" b="1" dirty="0">
                <a:solidFill>
                  <a:srgbClr val="FF0000"/>
                </a:solidFill>
              </a:rPr>
              <a:t>	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107296" y="33117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Makatoxin-1 </a:t>
            </a:r>
            <a:r>
              <a:rPr lang="en-US" sz="2000" dirty="0" smtClean="0"/>
              <a:t>                                          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56569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endParaRPr lang="fr-FR" b="1" dirty="0" smtClean="0"/>
          </a:p>
          <a:p>
            <a:pPr algn="ctr"/>
            <a:endParaRPr lang="fr-FR" b="1" dirty="0"/>
          </a:p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40,24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98,46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5425212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12290" name="Picture 2" descr="C:\Users\Khadija\Desktop\sUPP\D8UWD3 (Sodium channel neurotoxin MeuNaTxalpha-7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782" y="4800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619396"/>
            <a:ext cx="925487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 smtClean="0"/>
              <a:t>  </a:t>
            </a:r>
            <a:r>
              <a:rPr lang="fr-FR" sz="2000" b="1" dirty="0" err="1" smtClean="0"/>
              <a:t>Database</a:t>
            </a:r>
            <a:r>
              <a:rPr lang="fr-FR" sz="2000" b="1" dirty="0" smtClean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</a:p>
          <a:p>
            <a:endParaRPr lang="fr-FR" sz="2000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ARDGYIADDKNCAYFCGRNAYCDEECKKKGAESGYCQWAGQYGNACWCYKLPDKVPIKVSGKCNGR</a:t>
            </a:r>
            <a:endParaRPr lang="fr-FR" sz="2000" b="1" dirty="0" smtClean="0">
              <a:solidFill>
                <a:srgbClr val="FF0000"/>
              </a:solidFill>
            </a:endParaRPr>
          </a:p>
          <a:p>
            <a:endParaRPr lang="fr-FR" sz="2000" dirty="0"/>
          </a:p>
          <a:p>
            <a:r>
              <a:rPr lang="fr-FR" sz="2000" dirty="0" smtClean="0"/>
              <a:t> 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Sodium </a:t>
            </a:r>
            <a:r>
              <a:rPr lang="en-US" sz="2000" b="1" dirty="0"/>
              <a:t>channel neurotoxin MeuNaTxalpha-7</a:t>
            </a:r>
            <a:r>
              <a:rPr lang="en-US" sz="2000" b="1" dirty="0" smtClean="0"/>
              <a:t> </a:t>
            </a:r>
            <a:r>
              <a:rPr lang="fr-FR" sz="2000" b="1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D8UWD3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04137" y="4167664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95,24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5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9204378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13314" name="Picture 2" descr="C:\Users\Khadija\Desktop\sUPP\P0DMH9 (Chain (Alpha-toxin BmalphaTx47) [20-83] in Alpha-toxin BmalphaTx47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89" y="4167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IVISFALLLMTGVQSGRDAYIADSENCTYTCALNPYCNDLCTKNGAKSGYCQWAGRYGNACWCIDLPDKVPIRISGSCRGR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8774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Alpha-toxin BmalphaTx47) [20-83] in Alpha-toxin BmalphaTx47 </a:t>
            </a:r>
            <a:endParaRPr lang="fr-FR" sz="2000" dirty="0"/>
          </a:p>
          <a:p>
            <a:pPr algn="just"/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0DMH9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832670" y="3276600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40,24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75,29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82355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C:\Users\Khadija\Desktop\sUPP\P01483 (Neurotoxin Bot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167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RDAYIAQPENCVYECAKNSYCNDLCTKNGAKSGYCQWLGRWGNACYCIDLPDKVPIRIEGKCHF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Neurotoxin Bot2 </a:t>
            </a:r>
            <a:r>
              <a:rPr lang="en-US" sz="2000" dirty="0" smtClean="0"/>
              <a:t>				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01483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855674" y="3521333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40,24   Da         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</a:t>
            </a:r>
            <a:r>
              <a:rPr lang="en-US" b="1" dirty="0" smtClean="0">
                <a:solidFill>
                  <a:srgbClr val="FFC000"/>
                </a:solidFill>
              </a:rPr>
              <a:t>98,48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291840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15362" name="Picture 2" descr="C:\Users\Khadija\Desktop\sUPP\P17728 (Chain (Alpha-insect toxin LqhaIT) [20-85] in Alpha-insect toxin LqhaIT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04" y="3915728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619396"/>
            <a:ext cx="9254878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</a:t>
            </a:r>
            <a:r>
              <a:rPr lang="fr-FR" sz="2000" b="1" dirty="0" err="1" smtClean="0"/>
              <a:t>Database</a:t>
            </a:r>
            <a:r>
              <a:rPr lang="fr-FR" sz="2000" b="1" dirty="0" smtClean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>
                <a:solidFill>
                  <a:srgbClr val="FF0000"/>
                </a:solidFill>
              </a:rPr>
              <a:t>MNHLVMISLALLLLLGVESVRDAYIAKNYNCVYECFRDAYCNELCTKNGASSGYCQWAGKYGNACWCYALPDNVPIRVPGKCHRK	</a:t>
            </a:r>
            <a:endParaRPr lang="fr-FR" sz="2000" b="1" dirty="0" smtClean="0">
              <a:solidFill>
                <a:srgbClr val="FF0000"/>
              </a:solidFill>
            </a:endParaRPr>
          </a:p>
          <a:p>
            <a:endParaRPr lang="fr-FR" sz="2000" dirty="0" smtClean="0"/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Alpha-insect toxin </a:t>
            </a:r>
            <a:r>
              <a:rPr lang="en-US" sz="2000" b="1" dirty="0" err="1"/>
              <a:t>LqhaIT</a:t>
            </a:r>
            <a:r>
              <a:rPr lang="en-US" sz="2000" b="1" dirty="0"/>
              <a:t>) [20-85] in Alpha-insect toxin </a:t>
            </a:r>
            <a:r>
              <a:rPr lang="en-US" sz="2000" b="1" dirty="0" err="1"/>
              <a:t>LqhaIT</a:t>
            </a:r>
            <a:r>
              <a:rPr lang="en-US" sz="2000" b="1" dirty="0"/>
              <a:t> </a:t>
            </a:r>
            <a:r>
              <a:rPr lang="fr-FR" sz="2000" b="1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17728</a:t>
            </a:r>
            <a:r>
              <a:rPr lang="en-US" sz="2000" dirty="0"/>
              <a:t>	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04137" y="3505200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</a:t>
            </a:r>
            <a:r>
              <a:rPr lang="en-US" b="1" dirty="0" smtClean="0">
                <a:solidFill>
                  <a:srgbClr val="FFC000"/>
                </a:solidFill>
              </a:rPr>
              <a:t>  7173,2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77,64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807358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 descr="C:\Users\Khadija\Desktop\sUPP\P01496 (Chain (Toxin-3) [15-76] in Toxin-5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23" y="4175626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359498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LVVVCLLTAGTEGKKDGYPVEYDNCAYICWNYDNAYCDKLCKDKKADSGYCYWVHILCYCYGLPDSEPTKTNGKCKSGKK</a:t>
            </a:r>
            <a:r>
              <a:rPr lang="en-US" sz="2000" dirty="0"/>
              <a:t>	</a:t>
            </a:r>
            <a:endParaRPr lang="fr-FR" sz="2000" dirty="0" smtClean="0"/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Chain </a:t>
            </a:r>
            <a:r>
              <a:rPr lang="en-US" sz="2000" b="1" dirty="0"/>
              <a:t>(Toxin-3) [15-76] in Toxin-5</a:t>
            </a:r>
            <a:r>
              <a:rPr lang="en-US" sz="2000" dirty="0"/>
              <a:t>		</a:t>
            </a:r>
            <a:r>
              <a:rPr lang="fr-FR" sz="2000" dirty="0" smtClean="0"/>
              <a:t>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01496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867440" y="3288268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105,03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76,54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8192453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</a:t>
            </a:r>
            <a:r>
              <a:rPr lang="en-US" dirty="0" smtClean="0"/>
              <a:t>'</a:t>
            </a:r>
            <a:r>
              <a:rPr lang="en-US" dirty="0"/>
              <a:t>	</a:t>
            </a:r>
          </a:p>
        </p:txBody>
      </p:sp>
      <p:pic>
        <p:nvPicPr>
          <p:cNvPr id="17410" name="Picture 2" descr="C:\Users\Khadija\Desktop\sUPP\Q1EG64 (Chain [20-85] in Sodium toxin peptide BmKTb'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5859" y="4572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69806" y="1849945"/>
            <a:ext cx="9254878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VMISFAFLLMTGVESARDAYIAQNYNCVYHCARDAYCNELCTKNGAKSGSCPYLGEHKFACYCKDLPDNVPIRVPGKCNGG</a:t>
            </a:r>
            <a:r>
              <a:rPr lang="en-US" sz="2000" dirty="0"/>
              <a:t>	</a:t>
            </a:r>
          </a:p>
          <a:p>
            <a:endParaRPr lang="fr-FR" sz="2000" dirty="0" smtClean="0"/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[20-85] in Sodium toxin peptide </a:t>
            </a:r>
            <a:r>
              <a:rPr lang="en-US" sz="2000" b="1" dirty="0" err="1"/>
              <a:t>BmKTb</a:t>
            </a:r>
            <a:r>
              <a:rPr lang="en-US" sz="2000" b="1" dirty="0"/>
              <a:t> </a:t>
            </a:r>
            <a:endParaRPr lang="fr-FR" sz="2000" dirty="0"/>
          </a:p>
          <a:p>
            <a:pPr algn="just"/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1EG6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04137" y="4167664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321,09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77,64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86938789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8288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18434" name="Picture 2" descr="C:\Users\Khadija\Desktop\sUPP\P01488 (Alpha-like toxin Bom3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57641" y="4167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en-US" sz="2000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RDAYIAQPENCVYECAQNSYCNDLCTKNGATSGYCQWLGKYGNACWCKDLPDNVPIRIPGKCHF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lpha-toxin Bot1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0148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21390" y="3460298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</a:t>
            </a:r>
            <a:r>
              <a:rPr lang="en-US" b="1" dirty="0" smtClean="0">
                <a:solidFill>
                  <a:srgbClr val="FFC000"/>
                </a:solidFill>
              </a:rPr>
              <a:t>7074,14 Da                     </a:t>
            </a:r>
            <a:r>
              <a:rPr lang="en-US" b="1" dirty="0">
                <a:solidFill>
                  <a:srgbClr val="FFC000"/>
                </a:solidFill>
              </a:rPr>
              <a:t>Sequence </a:t>
            </a:r>
            <a:r>
              <a:rPr lang="en-US" b="1" dirty="0" smtClean="0">
                <a:solidFill>
                  <a:srgbClr val="FFC000"/>
                </a:solidFill>
              </a:rPr>
              <a:t>coverage:98,48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792980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379309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19458" name="Picture 2" descr="C:\Users\Khadija\Desktop\sUPP\P45698 (Chain (Neurotoxin BmK-M9) [15-78] in Neurotoxin BmK-M9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167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2086921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ISFALLLMTGVESVRDAYIAKPENCVYHCATNEGCNKLCTDNGAESGYCQWGGRYGNACWCIKLPDRVPIRVPGKCHR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Neurotoxin BmK-M9) [15-78] in Neurotoxin </a:t>
            </a:r>
            <a:r>
              <a:rPr lang="en-US" sz="2000" b="1" dirty="0" smtClean="0"/>
              <a:t>BmK-M9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4569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855674" y="3657600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015,19Da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</a:t>
            </a:r>
            <a:r>
              <a:rPr lang="en-US" b="1" dirty="0" smtClean="0">
                <a:solidFill>
                  <a:srgbClr val="FFC000"/>
                </a:solidFill>
              </a:rPr>
              <a:t>81,01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4165316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8288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20482" name="Picture 2" descr="C:\Users\Khadija\Desktop\sUPP\P83644 (Toxin Lqh4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5859" y="4536996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VRDAYIADDKNCVYTCGANSYCNTECTKNGAESGYCQWFGKYGNACWCIKLPDKVPIRIPGKCR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Toxin Lqh4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8364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865054" y="6078415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376001" y="3198168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155,25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48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419431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Khadija\Desktop\sUPP\P81240 (insect toxin LqhIT5) imp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1148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4" name="Rectangle 13"/>
          <p:cNvSpPr/>
          <p:nvPr/>
        </p:nvSpPr>
        <p:spPr>
          <a:xfrm>
            <a:off x="914400" y="3288268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>
                <a:solidFill>
                  <a:srgbClr val="FFC000"/>
                </a:solidFill>
              </a:rPr>
              <a:t>6670.79   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100 %</a:t>
            </a:r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</a:p>
          <a:p>
            <a:endParaRPr lang="fr-FR" sz="2000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DGYIRGGDGCKVSCVIDHVFCDNECKAAGGSYGYCWGWGLACWCEGLPADREWKYETNTCG</a:t>
            </a:r>
            <a:r>
              <a:rPr lang="en-US" sz="2000" dirty="0"/>
              <a:t>	</a:t>
            </a:r>
            <a:endParaRPr lang="fr-FR" sz="2000" dirty="0" smtClean="0"/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Insect toxin LqhIT5 </a:t>
            </a:r>
            <a:r>
              <a:rPr lang="fr-FR" sz="2000" dirty="0"/>
              <a:t>	</a:t>
            </a:r>
            <a:r>
              <a:rPr lang="fr-FR" sz="2000" dirty="0" smtClean="0"/>
              <a:t>			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81240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24430160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8288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21506" name="Picture 2" descr="C:\Users\Khadija\Desktop\sUPP\P01487 (Alpha-insect toxin Lqq3) imp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1630" y="4167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en-US" sz="2000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AYIAKNYNCVYECFRDSYCNDLCTKNGASSGYCQWAGKYGNACWCYALPDNVPIRVPGKCH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lpha-insect toxin Lqq3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01487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04137" y="3505200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6980,01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98.5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3891706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22530" name="Picture 2" descr="C:\Users\Khadija\Desktop\sUPP\H1ZZI7 (Toxin Tpa6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724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551563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SIFPIALALLLIGLEEGEAARDGYPLSKNNNCKIYCPDTDVCKDTCKNRASAPDGKCDGWNSCYCFKVPDHIPVWGDPGTKPCMT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Toxin </a:t>
            </a:r>
            <a:r>
              <a:rPr lang="en-US" sz="2000" b="1" dirty="0" smtClean="0"/>
              <a:t>Tpa6</a:t>
            </a:r>
            <a:r>
              <a:rPr lang="en-US" sz="2000" dirty="0" smtClean="0"/>
              <a:t>                                                                        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H1ZZI7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04137" y="4167664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059,12 Da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74,41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733898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23554" name="Picture 2" descr="C:\Users\Khadija\Desktop\sUPP\B8XGY6 (Chain [20-85] in Putative alpha toxin Tx17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4724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6976" y="1353957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ILISLAVLLTSGVESVRDAYIAQNYNCVYTCFKDAYCNDLCTKNGATSGYCQWVGKYGNGCWCYALPDNVPIRVPGKCHSR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Chain </a:t>
            </a:r>
            <a:r>
              <a:rPr lang="en-US" sz="2000" b="1" dirty="0"/>
              <a:t>[20-85] in Putative alpha toxin </a:t>
            </a:r>
            <a:r>
              <a:rPr lang="en-US" sz="2000" b="1" dirty="0" smtClean="0"/>
              <a:t>Tx17</a:t>
            </a:r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B8XGY6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744135" y="3276600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313,2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77,64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3022933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 descr="C:\Users\Khadija\Desktop\sUPP\P81504 (Insect toxin AaHIT5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3447" y="4343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" y="1619396"/>
            <a:ext cx="92548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DGYIKRHDGCKVTCLINDNYCDTECKREGGSYGYCYSVGFACWCEGLPDDKAWKSETNTCD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Insect toxin AaHIT5</a:t>
            </a:r>
            <a:r>
              <a:rPr lang="fr-FR" sz="2000" b="1" dirty="0" smtClean="0"/>
              <a:t>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en-US" sz="2000" b="1" dirty="0" smtClean="0">
                <a:solidFill>
                  <a:srgbClr val="FF0000"/>
                </a:solidFill>
              </a:rPr>
              <a:t>P8150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744135" y="3475167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6894,89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38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0463072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413338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25602" name="Picture 2" descr="C:\Users\Khadija\Desktop\sUPP\P68722 (Chain (Beta-insect excitatory toxin LqhIT1b) [19-88] in Beta-insect excitatory toxin LqhIT1b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561998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35967" y="1914540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>
                <a:solidFill>
                  <a:srgbClr val="FF0000"/>
                </a:solidFill>
              </a:rPr>
              <a:t>MKFFLLFLVVLPIMGVLGKKNGYAVDSKGKAPECFLSNYCNNECTKVHYADKGYCCLLSCYCFGLNDDKKVLEISDTTKKYCDFTIIN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8774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Beta-insect excitatory toxin LqhIT1b) [19-88] in Beta-insect excitatory toxin LqhIT1b	</a:t>
            </a:r>
            <a:r>
              <a:rPr lang="en-US" sz="2000" b="1" dirty="0" smtClean="0"/>
              <a:t> </a:t>
            </a:r>
            <a:endParaRPr lang="fr-FR" sz="2000" dirty="0"/>
          </a:p>
          <a:p>
            <a:pPr algn="just"/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68722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304800" y="6053618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20636" y="3581400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924,56 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79,54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0245273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 descr="C:\Users\Khadija\Desktop\sUPP\P60257 (Toxin Boma6c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AYIAQNYNCVYTCFKDAHCNDLCTKNGASSGYCQWAGKYGNACWCYALPDNVPIRIPGKCHRK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Toxin </a:t>
            </a:r>
            <a:r>
              <a:rPr lang="en-US" sz="2000" b="1" dirty="0"/>
              <a:t>Boma6c</a:t>
            </a:r>
            <a:r>
              <a:rPr lang="en-US" sz="2000" dirty="0"/>
              <a:t>		</a:t>
            </a:r>
            <a:r>
              <a:rPr lang="en-US" sz="2000" dirty="0" smtClean="0"/>
              <a:t>                                 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60257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04137" y="6084332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07146" y="3657600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</a:t>
            </a:r>
            <a:r>
              <a:rPr lang="en-US" b="1" dirty="0" smtClean="0">
                <a:solidFill>
                  <a:srgbClr val="FFC000"/>
                </a:solidFill>
              </a:rPr>
              <a:t>7308,21 Da                     </a:t>
            </a:r>
            <a:r>
              <a:rPr lang="en-US" b="1" dirty="0">
                <a:solidFill>
                  <a:srgbClr val="FFC000"/>
                </a:solidFill>
              </a:rPr>
              <a:t>Sequence coverage: </a:t>
            </a:r>
            <a:r>
              <a:rPr lang="en-US" b="1" dirty="0" smtClean="0">
                <a:solidFill>
                  <a:srgbClr val="FFC000"/>
                </a:solidFill>
              </a:rPr>
              <a:t>98,5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8583010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27649" name="Picture 1" descr="C:\Users\Khadija\Desktop\sUPP\M1J7U4 (Putative sodium channel alpha-toxin Acra5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167664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-76200" y="1371600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GYIMIKDTNCKFSCNIFKKWEYCSPLCQSKGAETGYCYNFGCWCLDLPDDVPVYGDRGVICRTR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8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2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ZoneTexte 12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4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6" name="Rectangle 15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Putative sodium channel alpha-toxin Acra5 </a:t>
            </a:r>
            <a:r>
              <a:rPr lang="en-US" sz="2000" b="1" dirty="0" smtClean="0"/>
              <a:t>            </a:t>
            </a:r>
          </a:p>
          <a:p>
            <a:pPr algn="just"/>
            <a:r>
              <a:rPr lang="fr-FR" sz="2000" b="1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M1J7U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457200" y="3667830"/>
            <a:ext cx="77997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7741,51 </a:t>
            </a:r>
            <a:r>
              <a:rPr lang="en-US" b="1" dirty="0" smtClean="0">
                <a:solidFill>
                  <a:srgbClr val="FFC000"/>
                </a:solidFill>
              </a:rPr>
              <a:t>Da                                     Sequence </a:t>
            </a:r>
            <a:r>
              <a:rPr lang="en-US" b="1" dirty="0">
                <a:solidFill>
                  <a:srgbClr val="FFC000"/>
                </a:solidFill>
              </a:rPr>
              <a:t>coverage: </a:t>
            </a:r>
            <a:r>
              <a:rPr lang="en-US" b="1" dirty="0" smtClean="0">
                <a:solidFill>
                  <a:srgbClr val="FFC000"/>
                </a:solidFill>
              </a:rPr>
              <a:t>98,52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9795089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 descr="C:\Users\Khadija\Desktop\sUPP\Q9N682 (Chain (Neurotoxin BmK-M11) [20-83] in Neurotoxin BmK-M1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965" y="46482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VMISFALLLMTGVESVRDAYIAKPENCVYHCATNEGCNKLCTDNGAESGYCQWGGKYGNACWCIKLPDDVPIRVPGKCHR</a:t>
            </a:r>
            <a:r>
              <a:rPr lang="en-US" sz="2000" dirty="0"/>
              <a:t>	</a:t>
            </a:r>
            <a:endParaRPr lang="fr-FR" sz="2000" dirty="0" smtClean="0"/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Neurotoxin BmK-M11) [20-83] in Neurotoxin BmK-M11</a:t>
            </a:r>
            <a:r>
              <a:rPr lang="en-US" sz="2000" dirty="0"/>
              <a:t>	</a:t>
            </a:r>
            <a:r>
              <a:rPr lang="en-US" sz="2000" b="1" dirty="0" smtClean="0"/>
              <a:t> </a:t>
            </a:r>
            <a:r>
              <a:rPr lang="fr-FR" sz="2000" dirty="0" smtClean="0"/>
              <a:t>                                 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Q9N682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</p:txBody>
      </p:sp>
      <p:sp>
        <p:nvSpPr>
          <p:cNvPr id="16" name="Rectangle 15"/>
          <p:cNvSpPr/>
          <p:nvPr/>
        </p:nvSpPr>
        <p:spPr>
          <a:xfrm>
            <a:off x="866365" y="6134851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457200" y="3667830"/>
            <a:ext cx="77997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7179,21</a:t>
            </a:r>
            <a:r>
              <a:rPr lang="en-US" b="1" dirty="0" smtClean="0">
                <a:solidFill>
                  <a:srgbClr val="FFC000"/>
                </a:solidFill>
              </a:rPr>
              <a:t>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</a:t>
            </a:r>
            <a:r>
              <a:rPr lang="en-US" b="1" dirty="0" smtClean="0">
                <a:solidFill>
                  <a:srgbClr val="FFC000"/>
                </a:solidFill>
              </a:rPr>
              <a:t>77,38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5602232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0" y="28288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29697" name="Picture 1" descr="C:\Users\Khadija\Desktop\sUPP\P55903 (Beta-insect depressant toxin BotIT4)IMP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6956" y="3933056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-76200" y="1619396"/>
            <a:ext cx="92548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</a:t>
            </a:r>
            <a:r>
              <a:rPr lang="fr-FR" sz="2000" b="1" dirty="0" err="1" smtClean="0"/>
              <a:t>Database</a:t>
            </a:r>
            <a:r>
              <a:rPr lang="fr-FR" sz="2000" b="1" dirty="0" smtClean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</a:p>
          <a:p>
            <a:endParaRPr lang="en-US" sz="2000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  DGYIRRRDGCKVSCLFGNEGCDKECKAYGGSYGYCWTWGLACWCEGLPDDKTWKSETNTCG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7" name="Groupe 6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8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2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ZoneTexte 12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4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6" name="Rectangle 15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Beta-insect depressant toxin BotIT4       </a:t>
            </a:r>
            <a:r>
              <a:rPr lang="fr-FR" sz="2000" b="1" dirty="0"/>
              <a:t> </a:t>
            </a:r>
            <a:r>
              <a:rPr lang="fr-FR" sz="2000" b="1" dirty="0" smtClean="0"/>
              <a:t>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55903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914400" y="3288268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6837,96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100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2501343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 descr="C:\Users\Khadija\Desktop\sUPP\A0A0K0LBU9 (Chain [20-83] in Sodium channel blocker AbNaTx26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3447" y="44958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359498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>
                <a:solidFill>
                  <a:srgbClr val="FF0000"/>
                </a:solidFill>
              </a:rPr>
              <a:t>MRAALLLAFSSLILTGVLTKKSGYPTQHDGCKIWCVFNHFCSNYCETYGGSGYCYTWKLACWCDNIHDWVPTWSYATTKCRAK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dirty="0"/>
              <a:t>Chain [20-83] in Sodium channel blocker AbNaTx26 </a:t>
            </a:r>
            <a:endParaRPr lang="en-US" sz="2000" dirty="0" smtClean="0"/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/>
              <a:t>A0A0K0LBU9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789192" y="4109833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7505,2 </a:t>
            </a:r>
            <a:r>
              <a:rPr lang="en-US" b="1" dirty="0" smtClean="0">
                <a:solidFill>
                  <a:srgbClr val="FFC000"/>
                </a:solidFill>
              </a:rPr>
              <a:t>Da                                     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77,1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79295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Khadija\Desktop\sUPP\Q9NJC4 (Chain (Toxin BmKaTx17) [10-73] in Toxin BmKaTx17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40908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4" name="Rectangle 13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</a:t>
            </a:r>
            <a:r>
              <a:rPr lang="en-US" b="1" dirty="0" smtClean="0">
                <a:solidFill>
                  <a:srgbClr val="FFC000"/>
                </a:solidFill>
              </a:rPr>
              <a:t>  </a:t>
            </a:r>
            <a:r>
              <a:rPr lang="en-US" b="1" dirty="0">
                <a:solidFill>
                  <a:srgbClr val="FFC000"/>
                </a:solidFill>
              </a:rPr>
              <a:t>7062,13 Da                     Sequence coverage: 84 %</a:t>
            </a:r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228600" y="1771796"/>
            <a:ext cx="925487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 </a:t>
            </a:r>
            <a:endParaRPr lang="fr-FR" sz="2000" dirty="0" smtClean="0"/>
          </a:p>
        </p:txBody>
      </p:sp>
      <p:sp>
        <p:nvSpPr>
          <p:cNvPr id="16" name="Rectangle 15"/>
          <p:cNvSpPr/>
          <p:nvPr/>
        </p:nvSpPr>
        <p:spPr>
          <a:xfrm>
            <a:off x="152400" y="1981200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b="1" dirty="0" smtClean="0">
                <a:solidFill>
                  <a:srgbClr val="FF0000"/>
                </a:solidFill>
              </a:rPr>
              <a:t>LLMTGVESGRDAYIAKNYNCVYHCFRDDYCNGLCTENGADSGYCYLAGKYGNACWCINLPDDKPIRIPGKCHRR</a:t>
            </a:r>
            <a:r>
              <a:rPr lang="en-US" sz="2000" dirty="0"/>
              <a:t>	</a:t>
            </a:r>
            <a:endParaRPr lang="en-US" sz="2000" b="1" dirty="0" smtClean="0"/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3" name="Rectangle 2"/>
          <p:cNvSpPr/>
          <p:nvPr/>
        </p:nvSpPr>
        <p:spPr>
          <a:xfrm>
            <a:off x="178526" y="381000"/>
            <a:ext cx="88688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 smtClean="0"/>
              <a:t>Description</a:t>
            </a:r>
            <a:r>
              <a:rPr lang="en-US" b="1" dirty="0" smtClean="0"/>
              <a:t>: Chain </a:t>
            </a:r>
            <a:r>
              <a:rPr lang="en-US" b="1" dirty="0"/>
              <a:t>(Toxin BmKaTx17) [10-73] in Toxin BmKaTx17 </a:t>
            </a:r>
            <a:r>
              <a:rPr lang="en-US" b="1" dirty="0" smtClean="0"/>
              <a:t>              </a:t>
            </a:r>
            <a:r>
              <a:rPr lang="en-US" dirty="0" smtClean="0"/>
              <a:t>Accession</a:t>
            </a:r>
            <a:r>
              <a:rPr lang="en-US" b="1" dirty="0" smtClean="0"/>
              <a:t>: </a:t>
            </a:r>
            <a:r>
              <a:rPr lang="en-US" b="1" dirty="0">
                <a:solidFill>
                  <a:srgbClr val="FF0000"/>
                </a:solidFill>
              </a:rPr>
              <a:t>Q9NJC4</a:t>
            </a:r>
            <a:endParaRPr lang="fr-FR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3116190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73357" y="121928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31745" name="Picture 1" descr="C:\Users\Khadija\Desktop\sUPP\P0C910 (Alpha-toxin Amm3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669" y="4051829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-76200" y="1619396"/>
            <a:ext cx="92548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GRDGYIVDTKNCVYHCYPPCDGLCKKNQAKSGSCGFLYPSGLACWCVALPENVPIKDPNDDCHK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8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2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ZoneTexte 12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4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6" name="Rectangle 15"/>
          <p:cNvSpPr/>
          <p:nvPr/>
        </p:nvSpPr>
        <p:spPr>
          <a:xfrm>
            <a:off x="97123" y="0"/>
            <a:ext cx="872667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lpha-toxin Amm3 </a:t>
            </a:r>
            <a:r>
              <a:rPr lang="fr-FR" sz="2000" b="1" dirty="0"/>
              <a:t> </a:t>
            </a:r>
            <a:r>
              <a:rPr lang="fr-FR" sz="2000" b="1" dirty="0" smtClean="0"/>
              <a:t>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en-US" sz="2000" b="1" dirty="0">
                <a:solidFill>
                  <a:srgbClr val="FF0000"/>
                </a:solidFill>
              </a:rPr>
              <a:t>P0C910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914400" y="3657600"/>
            <a:ext cx="734253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 7011,14 </a:t>
            </a:r>
            <a:r>
              <a:rPr lang="en-US" b="1" dirty="0" smtClean="0">
                <a:solidFill>
                  <a:srgbClr val="FFC000"/>
                </a:solidFill>
              </a:rPr>
              <a:t>Da                                     Sequence </a:t>
            </a:r>
            <a:r>
              <a:rPr lang="en-US" b="1" dirty="0">
                <a:solidFill>
                  <a:srgbClr val="FFC000"/>
                </a:solidFill>
              </a:rPr>
              <a:t>coverage:  98,46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0199242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 descr="C:\Users\Khadija\Desktop\sUPP\P59360 (Neurotoxin BmK-II) imp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075803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619396"/>
            <a:ext cx="953636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</a:t>
            </a:r>
            <a:r>
              <a:rPr lang="fr-FR" sz="2000" b="1" dirty="0" err="1" smtClean="0"/>
              <a:t>Database</a:t>
            </a:r>
            <a:r>
              <a:rPr lang="fr-FR" sz="2000" b="1" dirty="0" smtClean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  <a:endParaRPr lang="fr-FR" sz="2000" dirty="0"/>
          </a:p>
          <a:p>
            <a:endParaRPr lang="en-US" sz="2000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AYIAKPHNCVYECARNEYCNDLCTKDGAKSGYCQWVGKYGNGCWCIELPDNVPIRIPGNCH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Neurotoxin </a:t>
            </a:r>
            <a:r>
              <a:rPr lang="en-US" sz="2000" b="1" dirty="0" err="1" smtClean="0"/>
              <a:t>BmK</a:t>
            </a:r>
            <a:r>
              <a:rPr lang="en-US" sz="2000" b="1" dirty="0" smtClean="0"/>
              <a:t>-II 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59360 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914400" y="3657600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 7431,33</a:t>
            </a:r>
            <a:r>
              <a:rPr lang="en-US" b="1" dirty="0" smtClean="0">
                <a:solidFill>
                  <a:srgbClr val="FFC000"/>
                </a:solidFill>
              </a:rPr>
              <a:t>Da                                     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100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01500549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8288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33794" name="Picture 2" descr="C:\Users\Khadija\Desktop\sUPP\P56678 (Alpha-like toxin Lqh3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45" y="47244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Alpha-like toxin Lqh3</a:t>
            </a:r>
            <a:r>
              <a:rPr lang="en-US" sz="2000" b="1" dirty="0" smtClean="0"/>
              <a:t>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5667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865054" y="6184507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GYIAQPENCVYHCFPGSSGCDTLCKEKGGTSGHCGFKVGHGLACWCNALPDNVGIIVEGEKCHS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900731" y="3982998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>
                <a:solidFill>
                  <a:srgbClr val="FFC000"/>
                </a:solidFill>
              </a:rPr>
              <a:t>7215,31  Da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 Sequence </a:t>
            </a:r>
            <a:r>
              <a:rPr lang="en-US" b="1" dirty="0">
                <a:solidFill>
                  <a:srgbClr val="FFC000"/>
                </a:solidFill>
              </a:rPr>
              <a:t>coverage:  98,52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57895638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34818" name="Picture 2" descr="C:\Users\Khadija\Desktop\sUPP\P01497 (Chain (Beta-insect excitatory toxin 1) [19-88] in Beta-insect excitatory toxin 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5859" y="46482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8774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Chain (Beta-insect excitatory toxin 1) [19-88] in Beta-insect excitatory toxin </a:t>
            </a:r>
            <a:r>
              <a:rPr lang="en-US" sz="2000" b="1" dirty="0" smtClean="0"/>
              <a:t>1</a:t>
            </a:r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01497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96693" y="6116989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0" y="1657290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fr-FR" sz="2000" b="1" dirty="0">
                <a:solidFill>
                  <a:srgbClr val="FF0000"/>
                </a:solidFill>
              </a:rPr>
              <a:t>MKFLLLFLVVLPIMGVFGKKNGYAVDSSGKAPECLLSNYCNNECTKVHYADKGYCCLLSCYCFGLNDDKKVLEISDTRKSYCDTTIIN</a:t>
            </a:r>
          </a:p>
        </p:txBody>
      </p:sp>
      <p:sp>
        <p:nvSpPr>
          <p:cNvPr id="18" name="Rectangle 17"/>
          <p:cNvSpPr/>
          <p:nvPr/>
        </p:nvSpPr>
        <p:spPr>
          <a:xfrm>
            <a:off x="900731" y="3982998"/>
            <a:ext cx="761619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7928,54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79,54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3501104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[23-82] in Chain [23-82] in Meutoxin-3</a:t>
            </a:r>
            <a:r>
              <a:rPr lang="en-US" sz="2000" b="1" dirty="0" smtClean="0"/>
              <a:t> </a:t>
            </a:r>
            <a:r>
              <a:rPr lang="fr-FR" sz="2000" dirty="0"/>
              <a:t> </a:t>
            </a:r>
            <a:r>
              <a:rPr lang="fr-FR" sz="2000" dirty="0" smtClean="0"/>
              <a:t>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V9P3B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987649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KILTVFMIFIANFLSMTQVFSLKDRFLLINGSYELCLYEENLDEDCERLCKEQNASDGFCRQPHCFCADMPDDYPTRPTTR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900731" y="3982998"/>
            <a:ext cx="755746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7074,13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73,17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326" y="4598100"/>
            <a:ext cx="9144000" cy="15546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9059185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36866" name="Picture 2" descr="C:\Users\Khadija\Desktop\sUPP\Q8T3T0 (Depressant insect toxin BmK ITa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00" y="449580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Depressant insect toxin </a:t>
            </a:r>
            <a:r>
              <a:rPr lang="en-US" sz="2000" b="1" dirty="0" err="1"/>
              <a:t>BmK</a:t>
            </a:r>
            <a:r>
              <a:rPr lang="en-US" sz="2000" b="1" dirty="0"/>
              <a:t> ITa1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8T3T0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605022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KLFLLLLISASMLIDGLVNADGYIRGSNGCKVSCLWGNEGCNKECGAYGASYGYCWTWGLACWCEGLPDDKTWKSESNTCGGKK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09601" y="3613666"/>
            <a:ext cx="763366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6632,71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71,76</a:t>
            </a:r>
            <a:r>
              <a:rPr lang="en-US" b="1" dirty="0">
                <a:solidFill>
                  <a:srgbClr val="FFC000"/>
                </a:solidFill>
              </a:rPr>
              <a:t>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7553616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37890" name="Picture 2" descr="C:\Users\Khadija\Desktop\sUPP\Q9GQW3 (Chain (Toxin BmKaIT1) [20-83] in Toxin BmKaIT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5859" y="464820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Chain </a:t>
            </a:r>
            <a:r>
              <a:rPr lang="en-US" sz="2000" b="1" dirty="0"/>
              <a:t>(Toxin BmKaIT1) [20-83] in Toxin BmKaIT1</a:t>
            </a:r>
            <a:r>
              <a:rPr lang="fr-FR" sz="2000" b="1" dirty="0" smtClean="0"/>
              <a:t>                                                                                       </a:t>
            </a:r>
          </a:p>
          <a:p>
            <a:pPr algn="just"/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9GQW3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6220178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VMISFAFLLMTGVESVRDAYIAQNYNCVYHCARDAYCNELCTKNGAKSGSCPYLGEHKFACYCKDLPDNVPIRVPGKCHRR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900731" y="3982998"/>
            <a:ext cx="775750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7012,23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75,29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11209952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38914" name="Picture 2" descr="C:\Users\Khadija\Desktop\sUPP\Q95WX6 (Beta-insect depressant toxin BmKITb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65" y="457200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Beta-insect depressant toxin </a:t>
            </a:r>
            <a:r>
              <a:rPr lang="en-US" sz="2000" b="1" dirty="0" err="1" smtClean="0"/>
              <a:t>BmKITb</a:t>
            </a:r>
            <a:r>
              <a:rPr lang="en-US" sz="2000" b="1" dirty="0" smtClean="0"/>
              <a:t>                  </a:t>
            </a:r>
            <a:r>
              <a:rPr lang="fr-FR" sz="2000" b="1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en-US" sz="2000" b="1" dirty="0">
                <a:solidFill>
                  <a:srgbClr val="FF0000"/>
                </a:solidFill>
              </a:rPr>
              <a:t>Q95WX6</a:t>
            </a:r>
            <a:r>
              <a:rPr lang="en-US" sz="2000" dirty="0"/>
              <a:t>	</a:t>
            </a:r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6220178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48565" y="1570458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KLFLLLVISASMLIDGLVNADGYIRGSNGCKVSCLWGNEGCNKECKAFGAYYGYCWTWGLACWCQGLPDDKTWKSESNTCGGKK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789192" y="3581400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6775,93  </a:t>
            </a:r>
            <a:r>
              <a:rPr lang="en-US" b="1" dirty="0">
                <a:solidFill>
                  <a:srgbClr val="FFC000"/>
                </a:solidFill>
              </a:rPr>
              <a:t>Da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   Sequence </a:t>
            </a:r>
            <a:r>
              <a:rPr lang="en-US" b="1" dirty="0">
                <a:solidFill>
                  <a:srgbClr val="FFC000"/>
                </a:solidFill>
              </a:rPr>
              <a:t>coverage:  71,76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913182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 descr="C:\Users\Khadija\Desktop\sUPP\P0C5H1 (Beta-toxin Isom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965" y="464820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Beta-toxin </a:t>
            </a:r>
            <a:r>
              <a:rPr lang="en-US" sz="2000" b="1" dirty="0"/>
              <a:t>Isom1	</a:t>
            </a:r>
            <a:r>
              <a:rPr lang="en-US" sz="2000" dirty="0"/>
              <a:t>	</a:t>
            </a:r>
            <a:r>
              <a:rPr lang="en-US" sz="2000" dirty="0" smtClean="0"/>
              <a:t>                       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0C5H1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KKNGYAVDSSGKAPECLLSNYCNNECTKVHYADKGYCCLLSCYCFGLSDDKKVLEISDTRKKYCDYTIIN</a:t>
            </a:r>
            <a:r>
              <a:rPr lang="en-US" sz="2000" b="1" dirty="0">
                <a:solidFill>
                  <a:srgbClr val="FF0000"/>
                </a:solidFill>
              </a:rPr>
              <a:t>	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900731" y="3982998"/>
            <a:ext cx="76361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7895,47</a:t>
            </a:r>
            <a:r>
              <a:rPr lang="en-US" b="1" dirty="0" smtClean="0">
                <a:solidFill>
                  <a:srgbClr val="FFC000"/>
                </a:solidFill>
              </a:rPr>
              <a:t>  Da                                     Sequence coverage:  98,59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3472706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2" descr="C:\Users\Khadija\Desktop\sUPP\Q9GNG8 (Toxin BmKaTX15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28600" y="4199768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Toxin BmKaTX15 </a:t>
            </a:r>
            <a:r>
              <a:rPr lang="fr-FR" sz="2000" b="1" dirty="0" smtClean="0"/>
              <a:t>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9GNG8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807327" y="3429000"/>
            <a:ext cx="83765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7211,14  Da                                     Sequence coverage</a:t>
            </a:r>
            <a:r>
              <a:rPr lang="en-US" b="1" dirty="0">
                <a:solidFill>
                  <a:srgbClr val="FFC000"/>
                </a:solidFill>
              </a:rPr>
              <a:t>:  </a:t>
            </a:r>
            <a:r>
              <a:rPr lang="en-US" b="1" dirty="0" smtClean="0">
                <a:solidFill>
                  <a:srgbClr val="FFC000"/>
                </a:solidFill>
              </a:rPr>
              <a:t>77,64%</a:t>
            </a:r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YLVFFSLALLVMTGVESVRDGYIADDKNCAYFCGRNAYCDDECKKNGAESGYCQWAGVYGNACWCYKLPDKVPIRVPGKCNGG</a:t>
            </a:r>
            <a:endParaRPr lang="fr-FR" sz="2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29954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447800" y="797511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6146" name="Picture 2" descr="C:\Users\Khadija\Desktop\sUPP\Q4TUA4 (Chain (Alpha-toxin 4) [20-85] in Alpha-toxin 4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965" y="40908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22860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MNYLVFFSLALLLMTGVESVRDGYIADDKNCAYFCGRNAYCDDECKKKGAESGYCQWAGVYGNACWCYKLPDKVPIRVPGRCNGG</a:t>
            </a:r>
            <a:r>
              <a:rPr lang="en-US" sz="2000" dirty="0"/>
              <a:t>		</a:t>
            </a:r>
            <a:r>
              <a:rPr lang="fr-FR" sz="2000" dirty="0" smtClean="0"/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-8965" y="155466"/>
            <a:ext cx="8985164" cy="12618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Alpha-toxin 4) [20-85] in Alpha-toxin 4</a:t>
            </a:r>
            <a:r>
              <a:rPr lang="en-US" sz="2000" b="1" dirty="0" smtClean="0"/>
              <a:t>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4TUA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218,31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77,64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7221193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5" name="Picture 1" descr="C:\Users\Khadija\Desktop\sUPP\M1JMR8 (Sodium channel alpha-toxin Acra8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5942" y="4158485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Groupe 6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8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2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ZoneTexte 12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4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6" name="Rectangle 15"/>
          <p:cNvSpPr/>
          <p:nvPr/>
        </p:nvSpPr>
        <p:spPr>
          <a:xfrm>
            <a:off x="97123" y="234401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Sodium </a:t>
            </a:r>
            <a:r>
              <a:rPr lang="en-US" sz="2000" b="1" dirty="0"/>
              <a:t>channel alpha-toxin Acra8</a:t>
            </a:r>
            <a:r>
              <a:rPr lang="en-US" sz="2000" dirty="0"/>
              <a:t>			</a:t>
            </a:r>
          </a:p>
          <a:p>
            <a:pPr algn="just"/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M1JMR8</a:t>
            </a:r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914400" y="3288268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7218,3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98,5  %</a:t>
            </a:r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-6976" y="1964829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GYIVDDKNCTFFCGRNAYCNDECKKKGGESGYCQWASPYGNACWCYKLPDRVPIKEKGRCNGR</a:t>
            </a:r>
            <a:endParaRPr lang="fr-FR" sz="2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3541042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200400" y="4572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43010" name="Picture 2" descr="C:\Users\Khadija\Desktop\sUPP\A0A0U4RDS7 (Chain [20-87] in Sodium channel toxin NaTx4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00" y="402953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NHLVMISLAFLFMTGVASVRDGYIAQPETCAYHCIPGSSGCYTLCKEKKGESGHCGWKSGHGSAWWCNDLPDKEGIIVDGKGCTRR</a:t>
            </a:r>
            <a:r>
              <a:rPr lang="en-US" sz="2000" dirty="0"/>
              <a:t>	</a:t>
            </a:r>
            <a:endParaRPr lang="fr-FR" sz="2000" b="1" dirty="0"/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[20-87] in Sodium channel toxin NaTx4 </a:t>
            </a:r>
            <a:endParaRPr lang="en-US" sz="2000" b="1" dirty="0" smtClean="0"/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A0A0U4RDS7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14400" y="3288268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7243,29  </a:t>
            </a:r>
            <a:r>
              <a:rPr lang="en-US" b="1" dirty="0">
                <a:solidFill>
                  <a:srgbClr val="FFC000"/>
                </a:solidFill>
              </a:rPr>
              <a:t>Da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  Sequence coverage: 78,16</a:t>
            </a:r>
            <a:r>
              <a:rPr lang="en-US" b="1" dirty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1256559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2" descr="C:\Users\Khadija\Desktop\sUPP\P82814 (Insect toxin BsIT4)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4029165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1524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</a:t>
            </a:r>
            <a:r>
              <a:rPr lang="fr-FR" sz="2000" b="1" dirty="0" err="1" smtClean="0"/>
              <a:t>Database</a:t>
            </a:r>
            <a:r>
              <a:rPr lang="fr-FR" sz="2000" b="1" dirty="0" smtClean="0"/>
              <a:t> </a:t>
            </a:r>
            <a:r>
              <a:rPr lang="fr-FR" sz="2000" b="1" dirty="0" err="1" smtClean="0"/>
              <a:t>sequence</a:t>
            </a:r>
            <a:r>
              <a:rPr lang="fr-FR" sz="2000" b="1" dirty="0" smtClean="0"/>
              <a:t>:</a:t>
            </a:r>
          </a:p>
          <a:p>
            <a:endParaRPr lang="fr-FR" sz="2000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  DGYIKGNKGCKVSCVINNVFCNSMCKSSGGSYGYCWSWGLACWCEGLPAAKKWLYAATNTCG	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72777" y="472351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Insect toxin BsIT4</a:t>
            </a:r>
            <a:r>
              <a:rPr lang="en-US" sz="2000" dirty="0" smtClean="0"/>
              <a:t>		                                   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P8281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914400" y="3288268"/>
            <a:ext cx="73425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6954,15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100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1585950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</a:t>
            </a:r>
          </a:p>
        </p:txBody>
      </p:sp>
      <p:pic>
        <p:nvPicPr>
          <p:cNvPr id="45058" name="Picture 2" descr="C:\Users\Khadija\Desktop\sUPP\B8XGX9 (Chain [20-87] in Putative alpha toxin Tx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80060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:</a:t>
            </a:r>
          </a:p>
          <a:p>
            <a:endParaRPr lang="en-US" sz="2000" b="1" dirty="0" smtClean="0">
              <a:solidFill>
                <a:srgbClr val="FF0000"/>
              </a:solidFill>
            </a:endParaRPr>
          </a:p>
          <a:p>
            <a:r>
              <a:rPr lang="en-US" sz="2000" b="1" dirty="0" smtClean="0">
                <a:solidFill>
                  <a:srgbClr val="FF0000"/>
                </a:solidFill>
              </a:rPr>
              <a:t>MNYLIMISLALLLMTGVESGTGVRDAYIADDKNCVYTCALNSYCNTECTKNGAESGYCQWLGQYGNACWCIKLPDRVPIRIPGKCRG</a:t>
            </a:r>
            <a:r>
              <a:rPr lang="fr-FR" sz="2000" dirty="0" smtClean="0"/>
              <a:t> 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[20-87] in Putative alpha toxin Tx2	 </a:t>
            </a:r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B8XGX9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756271" y="4287964"/>
            <a:ext cx="75711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7394,28 </a:t>
            </a:r>
            <a:r>
              <a:rPr lang="en-US" b="1" dirty="0" smtClean="0">
                <a:solidFill>
                  <a:srgbClr val="FFC000"/>
                </a:solidFill>
              </a:rPr>
              <a:t>Da                                     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78,16 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40463004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2" descr="C:\Users\Khadija\Desktop\sUPP\Q17254 (Alpha-insect toxin Bot14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6894" y="464820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Signal peptide:</a:t>
            </a:r>
          </a:p>
          <a:p>
            <a:endParaRPr lang="fr-FR" sz="2000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SSLMISTAMKGKAPYRQVRDGYIAQPHNCAYHCLKISSGCDTLCKENGATSGHCGHKSGHGSACWCKDLPDKVGIIVHGEKCHR</a:t>
            </a:r>
            <a:r>
              <a:rPr lang="fr-FR" sz="2000" dirty="0" smtClean="0"/>
              <a:t> 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Alpha-insect </a:t>
            </a:r>
            <a:r>
              <a:rPr lang="en-US" sz="2000" b="1" dirty="0"/>
              <a:t>toxin Bot14</a:t>
            </a:r>
            <a:r>
              <a:rPr lang="en-US" sz="2000" dirty="0"/>
              <a:t>		</a:t>
            </a:r>
            <a:r>
              <a:rPr lang="en-US" sz="2000" dirty="0" smtClean="0"/>
              <a:t>                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Q17254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756272" y="3505200"/>
            <a:ext cx="75711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7184,3 </a:t>
            </a:r>
            <a:r>
              <a:rPr lang="en-US" b="1" dirty="0" smtClean="0">
                <a:solidFill>
                  <a:srgbClr val="FFC000"/>
                </a:solidFill>
              </a:rPr>
              <a:t>Da                                     Sequence </a:t>
            </a:r>
            <a:r>
              <a:rPr lang="en-US" b="1" dirty="0">
                <a:solidFill>
                  <a:srgbClr val="FFC000"/>
                </a:solidFill>
              </a:rPr>
              <a:t>coverage:  </a:t>
            </a:r>
            <a:r>
              <a:rPr lang="en-US" b="1" dirty="0" smtClean="0">
                <a:solidFill>
                  <a:srgbClr val="FFC000"/>
                </a:solidFill>
              </a:rPr>
              <a:t>78,82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346714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2" descr="C:\Users\Khadija\Desktop\sUPP\A0A059UI30 (Chain (Potassium channel toxin Meg-beta-KTx1) [28-91] in Potassium channel toxin Meg-beta-KTx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00" y="4267200"/>
            <a:ext cx="9104400" cy="15478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-35639" y="1676400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QRNLVVLLFLGMVALSSCGLREKHFQKLVKYAVPEGTLRTIIQTAVHKLGKTQFGCPAYQGYCDDHCQDIKKQEGFCHGFKCKCGIPMGF</a:t>
            </a:r>
            <a:endParaRPr lang="fr-FR" sz="2000" b="1" dirty="0">
              <a:solidFill>
                <a:srgbClr val="FF0000"/>
              </a:solidFill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8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2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ZoneTexte 12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4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6" name="Rectangle 15"/>
          <p:cNvSpPr/>
          <p:nvPr/>
        </p:nvSpPr>
        <p:spPr>
          <a:xfrm>
            <a:off x="19510" y="0"/>
            <a:ext cx="8895890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Chain (Potassium channel toxin Meg-beta-KTx1) [28-91] in Potassium channel toxin </a:t>
            </a:r>
            <a:r>
              <a:rPr lang="en-US" sz="2000" b="1" dirty="0" smtClean="0"/>
              <a:t>Meg-beta-KTx1</a:t>
            </a:r>
          </a:p>
          <a:p>
            <a:pPr algn="just"/>
            <a:endParaRPr lang="en-US" sz="2000" dirty="0"/>
          </a:p>
          <a:p>
            <a:pPr algn="just"/>
            <a:r>
              <a:rPr lang="fr-FR" sz="2000" dirty="0" smtClean="0"/>
              <a:t>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 smtClean="0">
                <a:solidFill>
                  <a:srgbClr val="FF0000"/>
                </a:solidFill>
              </a:rPr>
              <a:t>A0A059UI30</a:t>
            </a:r>
          </a:p>
          <a:p>
            <a:pPr algn="just"/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756272" y="3505200"/>
            <a:ext cx="75711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6889,3</a:t>
            </a:r>
            <a:r>
              <a:rPr lang="en-US" b="1" dirty="0" smtClean="0">
                <a:solidFill>
                  <a:srgbClr val="FFC000"/>
                </a:solidFill>
              </a:rPr>
              <a:t>Da                                     Sequence </a:t>
            </a:r>
            <a:r>
              <a:rPr lang="en-US" b="1" dirty="0">
                <a:solidFill>
                  <a:srgbClr val="FFC000"/>
                </a:solidFill>
              </a:rPr>
              <a:t>coverage:  70,32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9318405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</a:t>
            </a:r>
          </a:p>
        </p:txBody>
      </p:sp>
      <p:pic>
        <p:nvPicPr>
          <p:cNvPr id="48130" name="Picture 2" descr="C:\Users\Khadija\Desktop\sUPP\Q9N661 (Potassium channel toxin BmTXK-beta-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00" y="5029200"/>
            <a:ext cx="9104400" cy="591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-76200" y="16193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QRNLVVLLFLGMVALSSCGLREKHFQKLVKYAVPEGTLRTIIQTAVHKLGKTQFGCPAYQGYCDDHCQDIKKEEGFCHGFKCKCGIPMGF		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err="1" smtClean="0"/>
              <a:t>Description</a:t>
            </a:r>
            <a:r>
              <a:rPr lang="en-US" sz="2000" b="1" dirty="0" err="1" smtClean="0"/>
              <a:t>:</a:t>
            </a:r>
            <a:r>
              <a:rPr lang="en-US" sz="2000" b="1" dirty="0" err="1"/>
              <a:t>Potassium</a:t>
            </a:r>
            <a:r>
              <a:rPr lang="en-US" sz="2000" b="1" dirty="0"/>
              <a:t> channel toxin BmTXK-beta-2	</a:t>
            </a:r>
            <a:r>
              <a:rPr lang="en-US" sz="2000" b="1" dirty="0" smtClean="0"/>
              <a:t>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fr-FR" sz="2000" b="1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Q9N661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786430" y="4311134"/>
            <a:ext cx="75711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fr-FR" b="1" dirty="0" smtClean="0">
                <a:solidFill>
                  <a:srgbClr val="FFC000"/>
                </a:solidFill>
              </a:rPr>
              <a:t>2506,46</a:t>
            </a:r>
            <a:r>
              <a:rPr lang="en-US" b="1" dirty="0" smtClean="0">
                <a:solidFill>
                  <a:srgbClr val="FFC000"/>
                </a:solidFill>
              </a:rPr>
              <a:t>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25,27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5745061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0" y="269033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49154" name="Picture 2" descr="C:\Users\Khadija\Desktop\sUPP\A0A0A1I6E7 (Antimicrobial peptide AcrAP1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5118" y="4953000"/>
            <a:ext cx="9104400" cy="5910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" y="1383652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:</a:t>
            </a:r>
          </a:p>
          <a:p>
            <a:endParaRPr lang="fr-FR" sz="2000" dirty="0"/>
          </a:p>
          <a:p>
            <a:r>
              <a:rPr lang="en-US" sz="2000" b="1" dirty="0">
                <a:solidFill>
                  <a:srgbClr val="FF0000"/>
                </a:solidFill>
              </a:rPr>
              <a:t>MEIKYLLTVFLVLLIVSDHCQAFLFSLIPHAISGLISAFKGRRKRDLDGQIDRFRNFRKRDAELEELLSKLPIY	</a:t>
            </a:r>
            <a:r>
              <a:rPr lang="fr-FR" sz="2000" b="1" dirty="0" smtClean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Antimicrobial peptide AcrAP1 </a:t>
            </a:r>
            <a:r>
              <a:rPr lang="fr-FR" sz="2000" b="1" dirty="0"/>
              <a:t> </a:t>
            </a:r>
            <a:r>
              <a:rPr lang="fr-FR" sz="2000" b="1" dirty="0" smtClean="0"/>
              <a:t>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A0A0A1I6E7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8674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856583" y="3581400"/>
            <a:ext cx="75711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1959,13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24,32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0127765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178" name="Picture 2" descr="C:\Users\Khadija\Desktop\sUPP\F8THJ9 (Putative orcokinin)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588" y="4648200"/>
            <a:ext cx="8785412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0" y="1274449"/>
            <a:ext cx="9254878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 smtClean="0"/>
          </a:p>
          <a:p>
            <a:r>
              <a:rPr lang="en-US" sz="2000" b="1" dirty="0">
                <a:solidFill>
                  <a:srgbClr val="FF0000"/>
                </a:solidFill>
              </a:rPr>
              <a:t>MMFGIWILCGTAFFFCHVDAYLEYSNMAPGYNALVRRRSMKQPSEGRMFDNLGYNQESLVKRNFDEIDNVGFNDFGPASRPGSGRSWFPKRNWELARYNLRRLVKRATQDELMENKRQELDEIDKSGFGGFHKRNFDEIDRSGFNDFGKRSFDRFKLVRRADFNN</a:t>
            </a:r>
            <a:endParaRPr lang="fr-FR" sz="2000" b="1" dirty="0">
              <a:solidFill>
                <a:srgbClr val="FF0000"/>
              </a:solidFill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7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1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3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ZoneTexte 13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97123" y="287685"/>
            <a:ext cx="872667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Putative </a:t>
            </a:r>
            <a:r>
              <a:rPr lang="en-US" sz="2000" b="1" dirty="0" err="1"/>
              <a:t>orcokinin</a:t>
            </a:r>
            <a:r>
              <a:rPr lang="en-US" sz="2000" dirty="0"/>
              <a:t>	</a:t>
            </a:r>
            <a:r>
              <a:rPr lang="en-US" sz="2000" b="1" dirty="0" smtClean="0"/>
              <a:t>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 smtClean="0">
                <a:solidFill>
                  <a:srgbClr val="FF0000"/>
                </a:solidFill>
              </a:rPr>
              <a:t>F8THJ9</a:t>
            </a:r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6" name="Rectangle 15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685800" y="3288268"/>
            <a:ext cx="75711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3112,45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16,96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2511199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0" y="2551837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	</a:t>
            </a:r>
          </a:p>
        </p:txBody>
      </p:sp>
      <p:pic>
        <p:nvPicPr>
          <p:cNvPr id="51201" name="Picture 1" descr="C:\Users\Khadija\Desktop\sUPP\F1CIZ9 (Hypothetical secreted protein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191000"/>
            <a:ext cx="9144000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0" y="1501408"/>
            <a:ext cx="9254878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>
                <a:solidFill>
                  <a:srgbClr val="FF0000"/>
                </a:solidFill>
              </a:rPr>
              <a:t>MQNIFWILIGVGICITAVQCDSEMESSIRDILTKRRYLKYARSVLDDLNNQLDTLHKRSCVLNLPGMDCEYGDITGSGKDQDYWTSGRTPGKKRRSYCSLGIGNSEECLTKQLKDDMTDFNSWNDKFRPGKK</a:t>
            </a:r>
            <a:endParaRPr lang="fr-FR" sz="2000" b="1" dirty="0">
              <a:solidFill>
                <a:srgbClr val="FF0000"/>
              </a:solidFill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8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0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12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ZoneTexte 12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4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6" name="Rectangle 15"/>
          <p:cNvSpPr/>
          <p:nvPr/>
        </p:nvSpPr>
        <p:spPr>
          <a:xfrm>
            <a:off x="97123" y="2876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/>
              <a:t>Hypothetical secreted protein</a:t>
            </a:r>
            <a:r>
              <a:rPr lang="en-US" sz="2000" b="1" dirty="0" smtClean="0"/>
              <a:t> </a:t>
            </a:r>
            <a:r>
              <a:rPr lang="fr-FR" sz="2000" dirty="0"/>
              <a:t> </a:t>
            </a:r>
            <a:r>
              <a:rPr lang="fr-FR" sz="2000" dirty="0" smtClean="0"/>
              <a:t>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F1CIZ9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685800" y="3288268"/>
            <a:ext cx="75711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rgbClr val="FFC000"/>
                </a:solidFill>
              </a:rPr>
              <a:t>Measured</a:t>
            </a:r>
            <a:r>
              <a:rPr lang="fr-FR" b="1" dirty="0">
                <a:solidFill>
                  <a:srgbClr val="FFC000"/>
                </a:solidFill>
              </a:rPr>
              <a:t> MW: </a:t>
            </a:r>
            <a:r>
              <a:rPr lang="en-US" b="1" dirty="0" smtClean="0">
                <a:solidFill>
                  <a:srgbClr val="FFC000"/>
                </a:solidFill>
              </a:rPr>
              <a:t>3939,79  </a:t>
            </a:r>
            <a:r>
              <a:rPr lang="en-US" b="1" dirty="0">
                <a:solidFill>
                  <a:srgbClr val="FFC000"/>
                </a:solidFill>
              </a:rPr>
              <a:t>Da                                     </a:t>
            </a:r>
            <a:r>
              <a:rPr lang="en-US" b="1" dirty="0" smtClean="0">
                <a:solidFill>
                  <a:srgbClr val="FFC000"/>
                </a:solidFill>
              </a:rPr>
              <a:t>Sequence </a:t>
            </a:r>
            <a:r>
              <a:rPr lang="en-US" b="1" dirty="0">
                <a:solidFill>
                  <a:srgbClr val="FFC000"/>
                </a:solidFill>
              </a:rPr>
              <a:t>coverage:  25,75 </a:t>
            </a:r>
            <a:r>
              <a:rPr lang="en-US" b="1" dirty="0" smtClean="0">
                <a:solidFill>
                  <a:srgbClr val="FFC000"/>
                </a:solidFill>
              </a:rPr>
              <a:t>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4762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0" y="12954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	</a:t>
            </a:r>
          </a:p>
        </p:txBody>
      </p:sp>
      <p:pic>
        <p:nvPicPr>
          <p:cNvPr id="7169" name="Picture 1" descr="C:\Users\Khadija\Desktop\sUPP\P59863 (Beta-toxin BotIT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2412" y="4129619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228600" y="1771796"/>
            <a:ext cx="92548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</a:t>
            </a:r>
          </a:p>
          <a:p>
            <a:endParaRPr lang="fr-FR" sz="2000" b="1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DGYIKGYKGCKITCVINDDYCDTECKAEGGTYGYCWKWGLACWCEDLPDEKRWKSETNTC</a:t>
            </a:r>
            <a:endParaRPr lang="fr-FR" sz="2000" b="1" dirty="0" smtClean="0">
              <a:solidFill>
                <a:srgbClr val="FF0000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99427" y="152400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Beta-toxin BotIT2</a:t>
            </a:r>
            <a:r>
              <a:rPr lang="en-US" sz="2000" dirty="0"/>
              <a:t>	</a:t>
            </a:r>
            <a:r>
              <a:rPr lang="fr-FR" sz="2000" dirty="0" smtClean="0"/>
              <a:t>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 </a:t>
            </a:r>
            <a:r>
              <a:rPr lang="en-US" sz="2000" b="1" dirty="0">
                <a:solidFill>
                  <a:srgbClr val="FF0000"/>
                </a:solidFill>
              </a:rPr>
              <a:t>P59863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6564,78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98,36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48468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0" y="17526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8193" name="Picture 1" descr="C:\Users\Khadija\Desktop\sUPP\P60163 (Toxin Cg2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06" y="42792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4" name="Rectangle 13"/>
          <p:cNvSpPr/>
          <p:nvPr/>
        </p:nvSpPr>
        <p:spPr>
          <a:xfrm>
            <a:off x="1143000" y="3390379"/>
            <a:ext cx="345456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endParaRPr lang="fr-FR" b="1" dirty="0">
              <a:solidFill>
                <a:srgbClr val="FFC00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81985" y="1759163"/>
            <a:ext cx="8831167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 smtClean="0"/>
              <a:t> 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</a:t>
            </a:r>
            <a:r>
              <a:rPr lang="fr-FR" sz="2000" b="1" dirty="0" smtClean="0"/>
              <a:t>: </a:t>
            </a:r>
          </a:p>
          <a:p>
            <a:endParaRPr lang="fr-FR" sz="2000" b="1" dirty="0" smtClean="0"/>
          </a:p>
          <a:p>
            <a:r>
              <a:rPr lang="en-US" sz="2000" b="1" dirty="0" smtClean="0">
                <a:solidFill>
                  <a:srgbClr val="FF0000"/>
                </a:solidFill>
              </a:rPr>
              <a:t>KDGYLVNKSTGCKYSCIENINDSHCNEECISSIRKGSYGYCYKFYCYCIGMPDSTQVYPIPGKTCSTE</a:t>
            </a:r>
            <a:endParaRPr lang="fr-FR" sz="2000" b="1" dirty="0">
              <a:solidFill>
                <a:srgbClr val="FF0000"/>
              </a:solidFill>
            </a:endParaRPr>
          </a:p>
          <a:p>
            <a:endParaRPr lang="fr-FR" sz="2000" dirty="0" smtClean="0"/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Toxin </a:t>
            </a:r>
            <a:r>
              <a:rPr lang="en-US" sz="2000" b="1" dirty="0"/>
              <a:t>Cg2</a:t>
            </a:r>
            <a:r>
              <a:rPr lang="en-US" sz="2000" dirty="0"/>
              <a:t>		</a:t>
            </a:r>
            <a:r>
              <a:rPr lang="en-US" sz="2000" b="1" dirty="0" smtClean="0"/>
              <a:t>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60163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6871,92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88,4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08005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86000" y="1828800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		</a:t>
            </a:r>
          </a:p>
        </p:txBody>
      </p:sp>
      <p:pic>
        <p:nvPicPr>
          <p:cNvPr id="9217" name="Picture 1" descr="C:\Users\Khadija\Desktop\sUPP\P60256 (Toxin Boma6b)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37255" y="4038600"/>
            <a:ext cx="9105055" cy="154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8458200" y="6175274"/>
            <a:ext cx="725631" cy="758926"/>
            <a:chOff x="6400800" y="1058749"/>
            <a:chExt cx="844754" cy="758926"/>
          </a:xfrm>
        </p:grpSpPr>
        <p:pic>
          <p:nvPicPr>
            <p:cNvPr id="5" name="Picture 4" descr="W:\USMSP_4T\christian_395G\2016\results_AM\manips 20161024\20161024 AMP6 first manip\20161024 AMP6\P0C910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24" t="64619" r="58058"/>
            <a:stretch/>
          </p:blipFill>
          <p:spPr bwMode="auto">
            <a:xfrm>
              <a:off x="6400800" y="1082687"/>
              <a:ext cx="136733" cy="3707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ZoneTexte 5"/>
            <p:cNvSpPr txBox="1"/>
            <p:nvPr/>
          </p:nvSpPr>
          <p:spPr>
            <a:xfrm>
              <a:off x="649244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c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7" name="Picture 2" descr="W:\USMSP_4T\christian_395G\2016\results_AM\manips 20161024\20161024 AMP6 first manip\20161024 AMP6 reduit\P0C910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62754" r="94688"/>
            <a:stretch/>
          </p:blipFill>
          <p:spPr bwMode="auto">
            <a:xfrm>
              <a:off x="6781800" y="1082687"/>
              <a:ext cx="163717" cy="39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ZoneTexte 7"/>
            <p:cNvSpPr txBox="1"/>
            <p:nvPr/>
          </p:nvSpPr>
          <p:spPr>
            <a:xfrm>
              <a:off x="6945517" y="105874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z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pic>
          <p:nvPicPr>
            <p:cNvPr id="9" name="Picture 3" descr="W:\USMSP_4T\christian_395G\2016\results_AM\manips 20161024\20161024 AMP6 first manip\20161024 AMP6 redalk\P0C910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1" r="90671" b="62993"/>
            <a:stretch/>
          </p:blipFill>
          <p:spPr bwMode="auto">
            <a:xfrm>
              <a:off x="6808785" y="1428081"/>
              <a:ext cx="136732" cy="3877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ZoneTexte 9"/>
            <p:cNvSpPr txBox="1"/>
            <p:nvPr/>
          </p:nvSpPr>
          <p:spPr>
            <a:xfrm>
              <a:off x="6956692" y="1428081"/>
              <a:ext cx="288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y</a:t>
              </a:r>
              <a:endParaRPr lang="fr-FR" dirty="0">
                <a:solidFill>
                  <a:srgbClr val="0000FF"/>
                </a:solidFill>
              </a:endParaRPr>
            </a:p>
          </p:txBody>
        </p:sp>
        <p:pic>
          <p:nvPicPr>
            <p:cNvPr id="11" name="Picture 2" descr="W:\USMSP_4T\christian_395G\2016\results_AM\manips 20161024\20161024 AMP6 first manip\20161024 AMP6 reduit\P01481.pn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65242" r="61686"/>
            <a:stretch/>
          </p:blipFill>
          <p:spPr bwMode="auto">
            <a:xfrm>
              <a:off x="6432625" y="1453443"/>
              <a:ext cx="145279" cy="3642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ZoneTexte 11"/>
            <p:cNvSpPr txBox="1"/>
            <p:nvPr/>
          </p:nvSpPr>
          <p:spPr>
            <a:xfrm>
              <a:off x="6519923" y="143731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00FF"/>
                  </a:solidFill>
                </a:rPr>
                <a:t>b</a:t>
              </a:r>
              <a:endParaRPr lang="fr-FR" dirty="0">
                <a:solidFill>
                  <a:srgbClr val="0000FF"/>
                </a:solidFill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913517" y="5715000"/>
            <a:ext cx="74138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b="1" dirty="0" err="1" smtClean="0"/>
              <a:t>Identified</a:t>
            </a:r>
            <a:r>
              <a:rPr lang="fr-FR" b="1" dirty="0" smtClean="0"/>
              <a:t> </a:t>
            </a:r>
            <a:r>
              <a:rPr lang="fr-FR" b="1" dirty="0" err="1" smtClean="0"/>
              <a:t>amino</a:t>
            </a:r>
            <a:r>
              <a:rPr lang="fr-FR" b="1" dirty="0" smtClean="0"/>
              <a:t> </a:t>
            </a:r>
            <a:r>
              <a:rPr lang="fr-FR" b="1" dirty="0" err="1" smtClean="0"/>
              <a:t>acid</a:t>
            </a:r>
            <a:r>
              <a:rPr lang="fr-FR" b="1" dirty="0" smtClean="0"/>
              <a:t> </a:t>
            </a:r>
            <a:r>
              <a:rPr lang="fr-FR" b="1" dirty="0" err="1" smtClean="0"/>
              <a:t>sequence</a:t>
            </a:r>
            <a:endParaRPr lang="en-US" b="1" dirty="0"/>
          </a:p>
        </p:txBody>
      </p:sp>
      <p:sp>
        <p:nvSpPr>
          <p:cNvPr id="15" name="Rectangle 14"/>
          <p:cNvSpPr/>
          <p:nvPr/>
        </p:nvSpPr>
        <p:spPr>
          <a:xfrm>
            <a:off x="0" y="1771796"/>
            <a:ext cx="925487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2000" dirty="0"/>
              <a:t> </a:t>
            </a:r>
            <a:r>
              <a:rPr lang="fr-FR" sz="2000" b="1" dirty="0" err="1"/>
              <a:t>Database</a:t>
            </a:r>
            <a:r>
              <a:rPr lang="fr-FR" sz="2000" b="1" dirty="0"/>
              <a:t> </a:t>
            </a:r>
            <a:r>
              <a:rPr lang="fr-FR" sz="2000" b="1" dirty="0" err="1"/>
              <a:t>sequence</a:t>
            </a:r>
            <a:r>
              <a:rPr lang="fr-FR" sz="2000" b="1" dirty="0"/>
              <a:t> : </a:t>
            </a:r>
            <a:endParaRPr lang="fr-FR" sz="2000" b="1" dirty="0" smtClean="0"/>
          </a:p>
          <a:p>
            <a:endParaRPr lang="fr-FR" sz="2000" dirty="0"/>
          </a:p>
          <a:p>
            <a:r>
              <a:rPr lang="en-US" sz="2000" b="1" dirty="0" smtClean="0">
                <a:solidFill>
                  <a:srgbClr val="FF0000"/>
                </a:solidFill>
              </a:rPr>
              <a:t>VRDAYIAQNYNCVYDCARDAYCNELCTKNGAKSGHCEWFGPHGDACWCIDLPNNVPIKVEGKCHRK</a:t>
            </a:r>
            <a:r>
              <a:rPr lang="en-US" sz="2000" dirty="0"/>
              <a:t>		</a:t>
            </a:r>
            <a:r>
              <a:rPr lang="fr-FR" sz="2000" dirty="0" smtClean="0"/>
              <a:t>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49523" y="440085"/>
            <a:ext cx="8726676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b="1" dirty="0" smtClean="0"/>
          </a:p>
          <a:p>
            <a:pPr algn="just"/>
            <a:r>
              <a:rPr lang="en-US" sz="2000" dirty="0" smtClean="0"/>
              <a:t>Description</a:t>
            </a:r>
            <a:r>
              <a:rPr lang="en-US" sz="2000" b="1" dirty="0" smtClean="0"/>
              <a:t>: </a:t>
            </a:r>
            <a:r>
              <a:rPr lang="en-US" sz="2000" b="1" dirty="0"/>
              <a:t>Toxin Boma6b</a:t>
            </a:r>
            <a:r>
              <a:rPr lang="en-US" sz="2000" b="1" dirty="0" smtClean="0"/>
              <a:t> </a:t>
            </a:r>
            <a:r>
              <a:rPr lang="fr-FR" sz="2000" b="1" dirty="0"/>
              <a:t> </a:t>
            </a:r>
            <a:r>
              <a:rPr lang="fr-FR" sz="2000" b="1" dirty="0" smtClean="0"/>
              <a:t>                                                                </a:t>
            </a:r>
            <a:r>
              <a:rPr lang="en-US" sz="2000" dirty="0" smtClean="0"/>
              <a:t>Accession</a:t>
            </a:r>
            <a:r>
              <a:rPr lang="en-US" sz="2000" b="1" dirty="0" smtClean="0"/>
              <a:t>:</a:t>
            </a:r>
            <a:r>
              <a:rPr lang="en-US" sz="2000" dirty="0"/>
              <a:t> </a:t>
            </a:r>
            <a:r>
              <a:rPr lang="en-US" sz="2000" b="1" dirty="0">
                <a:solidFill>
                  <a:srgbClr val="FF0000"/>
                </a:solidFill>
              </a:rPr>
              <a:t>P60256</a:t>
            </a:r>
            <a:endParaRPr lang="fr-FR" sz="2000" b="1" dirty="0">
              <a:solidFill>
                <a:srgbClr val="FF0000"/>
              </a:solidFill>
            </a:endParaRPr>
          </a:p>
          <a:p>
            <a:pPr algn="just"/>
            <a:endParaRPr lang="fr-FR" sz="2000" b="1" dirty="0"/>
          </a:p>
          <a:p>
            <a:pPr algn="just"/>
            <a:endParaRPr lang="en-US" b="1" dirty="0"/>
          </a:p>
        </p:txBody>
      </p:sp>
      <p:sp>
        <p:nvSpPr>
          <p:cNvPr id="17" name="Rectangle 16"/>
          <p:cNvSpPr/>
          <p:nvPr/>
        </p:nvSpPr>
        <p:spPr>
          <a:xfrm>
            <a:off x="1143000" y="3390379"/>
            <a:ext cx="7432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 smtClean="0">
                <a:solidFill>
                  <a:srgbClr val="FFC000"/>
                </a:solidFill>
              </a:rPr>
              <a:t>Measured</a:t>
            </a:r>
            <a:r>
              <a:rPr lang="fr-FR" b="1" dirty="0" smtClean="0">
                <a:solidFill>
                  <a:srgbClr val="FFC000"/>
                </a:solidFill>
              </a:rPr>
              <a:t> MW:</a:t>
            </a:r>
            <a:r>
              <a:rPr lang="en-US" b="1" dirty="0">
                <a:solidFill>
                  <a:srgbClr val="FFC000"/>
                </a:solidFill>
              </a:rPr>
              <a:t>   </a:t>
            </a:r>
            <a:r>
              <a:rPr lang="en-US" b="1" dirty="0" smtClean="0">
                <a:solidFill>
                  <a:srgbClr val="FFC000"/>
                </a:solidFill>
              </a:rPr>
              <a:t>7307,23 </a:t>
            </a:r>
            <a:r>
              <a:rPr lang="en-US" b="1" dirty="0">
                <a:solidFill>
                  <a:srgbClr val="FFC000"/>
                </a:solidFill>
              </a:rPr>
              <a:t>Da                     Sequence coverage: </a:t>
            </a:r>
            <a:r>
              <a:rPr lang="en-US" b="1" dirty="0" smtClean="0">
                <a:solidFill>
                  <a:srgbClr val="FFC000"/>
                </a:solidFill>
              </a:rPr>
              <a:t>98,5 %</a:t>
            </a:r>
            <a:endParaRPr lang="fr-FR" b="1" dirty="0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844216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4</TotalTime>
  <Words>2319</Words>
  <Application>Microsoft Office PowerPoint</Application>
  <PresentationFormat>Affichage à l'écran (4:3)</PresentationFormat>
  <Paragraphs>824</Paragraphs>
  <Slides>69</Slides>
  <Notes>2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9</vt:i4>
      </vt:variant>
    </vt:vector>
  </HeadingPairs>
  <TitlesOfParts>
    <vt:vector size="70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ian</dc:creator>
  <cp:lastModifiedBy>Khadija</cp:lastModifiedBy>
  <cp:revision>57</cp:revision>
  <dcterms:created xsi:type="dcterms:W3CDTF">2017-01-04T08:22:07Z</dcterms:created>
  <dcterms:modified xsi:type="dcterms:W3CDTF">2021-02-18T16:45:01Z</dcterms:modified>
</cp:coreProperties>
</file>